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41" d="100"/>
          <a:sy n="41" d="100"/>
        </p:scale>
        <p:origin x="-2432" y="-12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385934-857F-FC40-8188-3A522463AE04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EB066C-DA7D-1640-87FF-6310A4E63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4676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 smtClean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E4E34F-7D17-494E-9C86-71B4D1662A77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E4E34F-7D17-494E-9C86-71B4D1662A77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670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99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325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070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043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595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5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666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501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898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886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E398C3-CA71-6A44-981C-41D9856ED23A}" type="datetimeFigureOut">
              <a:rPr lang="en-US" smtClean="0"/>
              <a:t>30/0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0D5C35-BB05-404C-88C2-3C427345B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851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4" Type="http://schemas.openxmlformats.org/officeDocument/2006/relationships/image" Target="../media/image2.jp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hAgo2 domains K402 and SKs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44" t="6775" r="7951" b="10047"/>
          <a:stretch/>
        </p:blipFill>
        <p:spPr>
          <a:xfrm>
            <a:off x="764704" y="635000"/>
            <a:ext cx="4122256" cy="3014133"/>
          </a:xfrm>
          <a:prstGeom prst="rect">
            <a:avLst/>
          </a:prstGeom>
        </p:spPr>
      </p:pic>
      <p:cxnSp>
        <p:nvCxnSpPr>
          <p:cNvPr id="7" name="Straight Connector 13"/>
          <p:cNvCxnSpPr/>
          <p:nvPr/>
        </p:nvCxnSpPr>
        <p:spPr>
          <a:xfrm>
            <a:off x="3212976" y="3300750"/>
            <a:ext cx="3094691" cy="3850950"/>
          </a:xfrm>
          <a:prstGeom prst="line">
            <a:avLst/>
          </a:prstGeom>
          <a:ln w="3175" cmpd="sng">
            <a:solidFill>
              <a:srgbClr val="00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10"/>
          <p:cNvCxnSpPr/>
          <p:nvPr/>
        </p:nvCxnSpPr>
        <p:spPr>
          <a:xfrm flipH="1">
            <a:off x="408333" y="3300750"/>
            <a:ext cx="356371" cy="3850950"/>
          </a:xfrm>
          <a:prstGeom prst="line">
            <a:avLst/>
          </a:prstGeom>
          <a:ln w="3175" cmpd="sng">
            <a:solidFill>
              <a:srgbClr val="00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6" name="Picture 15" descr="hAgo2 domains K402 and SKs 2.jp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00" b="16935"/>
          <a:stretch/>
        </p:blipFill>
        <p:spPr>
          <a:xfrm>
            <a:off x="408333" y="3832501"/>
            <a:ext cx="5899334" cy="3319199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" name="Straight Connector 6"/>
          <p:cNvCxnSpPr/>
          <p:nvPr/>
        </p:nvCxnSpPr>
        <p:spPr>
          <a:xfrm flipH="1">
            <a:off x="408333" y="2303716"/>
            <a:ext cx="356371" cy="1528785"/>
          </a:xfrm>
          <a:prstGeom prst="line">
            <a:avLst/>
          </a:prstGeom>
          <a:ln w="3175" cmpd="sng">
            <a:solidFill>
              <a:srgbClr val="00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7"/>
          <p:cNvCxnSpPr/>
          <p:nvPr/>
        </p:nvCxnSpPr>
        <p:spPr>
          <a:xfrm>
            <a:off x="3212976" y="2303716"/>
            <a:ext cx="3094691" cy="1528785"/>
          </a:xfrm>
          <a:prstGeom prst="line">
            <a:avLst/>
          </a:prstGeom>
          <a:ln w="3175" cmpd="sng">
            <a:solidFill>
              <a:srgbClr val="00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5"/>
          <p:cNvSpPr txBox="1"/>
          <p:nvPr/>
        </p:nvSpPr>
        <p:spPr>
          <a:xfrm>
            <a:off x="2092581" y="5277423"/>
            <a:ext cx="504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K402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10" name="TextBox 11"/>
          <p:cNvSpPr txBox="1"/>
          <p:nvPr/>
        </p:nvSpPr>
        <p:spPr>
          <a:xfrm>
            <a:off x="1756546" y="6021667"/>
            <a:ext cx="504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K212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11" name="TextBox 12"/>
          <p:cNvSpPr txBox="1"/>
          <p:nvPr/>
        </p:nvSpPr>
        <p:spPr>
          <a:xfrm>
            <a:off x="2535893" y="6160167"/>
            <a:ext cx="504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K739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12" name="TextBox 14"/>
          <p:cNvSpPr txBox="1"/>
          <p:nvPr/>
        </p:nvSpPr>
        <p:spPr>
          <a:xfrm>
            <a:off x="3590364" y="5744668"/>
            <a:ext cx="504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K39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13" name="TextBox 15"/>
          <p:cNvSpPr txBox="1"/>
          <p:nvPr/>
        </p:nvSpPr>
        <p:spPr>
          <a:xfrm>
            <a:off x="642806" y="6160167"/>
            <a:ext cx="504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K51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886960" y="152400"/>
            <a:ext cx="1793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_tradnl" dirty="0" err="1" smtClean="0"/>
              <a:t>Supp</a:t>
            </a:r>
            <a:r>
              <a:rPr lang="es-ES_tradnl" dirty="0" smtClean="0"/>
              <a:t>. Figure </a:t>
            </a:r>
            <a:r>
              <a:rPr lang="es-ES_tradnl" dirty="0"/>
              <a:t>1</a:t>
            </a:r>
          </a:p>
        </p:txBody>
      </p:sp>
      <p:sp>
        <p:nvSpPr>
          <p:cNvPr id="21" name="TextBox 14"/>
          <p:cNvSpPr txBox="1"/>
          <p:nvPr/>
        </p:nvSpPr>
        <p:spPr>
          <a:xfrm>
            <a:off x="1146861" y="4576268"/>
            <a:ext cx="6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Loop2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22" name="TextBox 14"/>
          <p:cNvSpPr txBox="1"/>
          <p:nvPr/>
        </p:nvSpPr>
        <p:spPr>
          <a:xfrm>
            <a:off x="3991661" y="5005667"/>
            <a:ext cx="6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PIWI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23" name="TextBox 14"/>
          <p:cNvSpPr txBox="1"/>
          <p:nvPr/>
        </p:nvSpPr>
        <p:spPr>
          <a:xfrm>
            <a:off x="5515661" y="4730535"/>
            <a:ext cx="6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MID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25" name="TextBox 14"/>
          <p:cNvSpPr txBox="1"/>
          <p:nvPr/>
        </p:nvSpPr>
        <p:spPr>
          <a:xfrm>
            <a:off x="1785120" y="2026717"/>
            <a:ext cx="6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Loop2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26" name="TextBox 14"/>
          <p:cNvSpPr txBox="1"/>
          <p:nvPr/>
        </p:nvSpPr>
        <p:spPr>
          <a:xfrm>
            <a:off x="2394636" y="2165216"/>
            <a:ext cx="6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PIWI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27" name="TextBox 14"/>
          <p:cNvSpPr txBox="1"/>
          <p:nvPr/>
        </p:nvSpPr>
        <p:spPr>
          <a:xfrm>
            <a:off x="3484903" y="1650984"/>
            <a:ext cx="6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MID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29" name="TextBox 5"/>
          <p:cNvSpPr txBox="1"/>
          <p:nvPr/>
        </p:nvSpPr>
        <p:spPr>
          <a:xfrm>
            <a:off x="1762382" y="4821001"/>
            <a:ext cx="12477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SUMO consensus seq.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3" name="Rectangle 4"/>
          <p:cNvSpPr/>
          <p:nvPr/>
        </p:nvSpPr>
        <p:spPr>
          <a:xfrm>
            <a:off x="764705" y="2303716"/>
            <a:ext cx="2448272" cy="997034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14"/>
          <p:cNvSpPr txBox="1"/>
          <p:nvPr/>
        </p:nvSpPr>
        <p:spPr>
          <a:xfrm>
            <a:off x="1955843" y="999051"/>
            <a:ext cx="60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PAZ</a:t>
            </a:r>
            <a:endParaRPr lang="en-US" sz="12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31" name="TextBox 14"/>
          <p:cNvSpPr txBox="1"/>
          <p:nvPr/>
        </p:nvSpPr>
        <p:spPr>
          <a:xfrm>
            <a:off x="2700704" y="1806733"/>
            <a:ext cx="8811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miR-20a</a:t>
            </a:r>
            <a:endParaRPr lang="en-US" sz="7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32" name="TextBox 14"/>
          <p:cNvSpPr txBox="1"/>
          <p:nvPr/>
        </p:nvSpPr>
        <p:spPr>
          <a:xfrm>
            <a:off x="1066681" y="1504847"/>
            <a:ext cx="8811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miR-20a</a:t>
            </a:r>
            <a:endParaRPr lang="en-US" sz="7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33" name="TextBox 14"/>
          <p:cNvSpPr txBox="1"/>
          <p:nvPr/>
        </p:nvSpPr>
        <p:spPr>
          <a:xfrm>
            <a:off x="4601177" y="5302824"/>
            <a:ext cx="8811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miR-20a</a:t>
            </a:r>
            <a:endParaRPr lang="en-US" sz="7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  <p:sp>
        <p:nvSpPr>
          <p:cNvPr id="34" name="TextBox 14"/>
          <p:cNvSpPr txBox="1"/>
          <p:nvPr/>
        </p:nvSpPr>
        <p:spPr>
          <a:xfrm>
            <a:off x="642806" y="4015890"/>
            <a:ext cx="8811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 smtClean="0"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miR-20a</a:t>
            </a:r>
            <a:endParaRPr lang="en-US" sz="700" b="1" dirty="0">
              <a:effectLst>
                <a:glow rad="101600">
                  <a:schemeClr val="bg1">
                    <a:alpha val="75000"/>
                  </a:schemeClr>
                </a:glo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32096361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Freeform 42"/>
          <p:cNvSpPr/>
          <p:nvPr/>
        </p:nvSpPr>
        <p:spPr>
          <a:xfrm>
            <a:off x="4868079" y="3358974"/>
            <a:ext cx="355608" cy="558522"/>
          </a:xfrm>
          <a:custGeom>
            <a:avLst/>
            <a:gdLst>
              <a:gd name="connsiteX0" fmla="*/ 131233 w 283633"/>
              <a:gd name="connsiteY0" fmla="*/ 0 h 482600"/>
              <a:gd name="connsiteX1" fmla="*/ 93133 w 283633"/>
              <a:gd name="connsiteY1" fmla="*/ 63500 h 482600"/>
              <a:gd name="connsiteX2" fmla="*/ 93133 w 283633"/>
              <a:gd name="connsiteY2" fmla="*/ 165100 h 482600"/>
              <a:gd name="connsiteX3" fmla="*/ 139700 w 283633"/>
              <a:gd name="connsiteY3" fmla="*/ 254000 h 482600"/>
              <a:gd name="connsiteX4" fmla="*/ 165100 w 283633"/>
              <a:gd name="connsiteY4" fmla="*/ 287867 h 482600"/>
              <a:gd name="connsiteX5" fmla="*/ 131233 w 283633"/>
              <a:gd name="connsiteY5" fmla="*/ 338667 h 482600"/>
              <a:gd name="connsiteX6" fmla="*/ 0 w 283633"/>
              <a:gd name="connsiteY6" fmla="*/ 440267 h 482600"/>
              <a:gd name="connsiteX7" fmla="*/ 0 w 283633"/>
              <a:gd name="connsiteY7" fmla="*/ 440267 h 482600"/>
              <a:gd name="connsiteX8" fmla="*/ 0 w 283633"/>
              <a:gd name="connsiteY8" fmla="*/ 440267 h 482600"/>
              <a:gd name="connsiteX9" fmla="*/ 0 w 283633"/>
              <a:gd name="connsiteY9" fmla="*/ 440267 h 482600"/>
              <a:gd name="connsiteX10" fmla="*/ 12700 w 283633"/>
              <a:gd name="connsiteY10" fmla="*/ 482600 h 482600"/>
              <a:gd name="connsiteX11" fmla="*/ 203200 w 283633"/>
              <a:gd name="connsiteY11" fmla="*/ 325967 h 482600"/>
              <a:gd name="connsiteX12" fmla="*/ 275167 w 283633"/>
              <a:gd name="connsiteY12" fmla="*/ 186267 h 482600"/>
              <a:gd name="connsiteX13" fmla="*/ 283633 w 283633"/>
              <a:gd name="connsiteY13" fmla="*/ 71967 h 482600"/>
              <a:gd name="connsiteX14" fmla="*/ 262467 w 283633"/>
              <a:gd name="connsiteY14" fmla="*/ 16934 h 482600"/>
              <a:gd name="connsiteX15" fmla="*/ 203200 w 283633"/>
              <a:gd name="connsiteY15" fmla="*/ 0 h 482600"/>
              <a:gd name="connsiteX16" fmla="*/ 131233 w 283633"/>
              <a:gd name="connsiteY16" fmla="*/ 0 h 482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283633" h="482600">
                <a:moveTo>
                  <a:pt x="131233" y="0"/>
                </a:moveTo>
                <a:lnTo>
                  <a:pt x="93133" y="63500"/>
                </a:lnTo>
                <a:lnTo>
                  <a:pt x="93133" y="165100"/>
                </a:lnTo>
                <a:lnTo>
                  <a:pt x="139700" y="254000"/>
                </a:lnTo>
                <a:lnTo>
                  <a:pt x="165100" y="287867"/>
                </a:lnTo>
                <a:lnTo>
                  <a:pt x="131233" y="338667"/>
                </a:lnTo>
                <a:lnTo>
                  <a:pt x="0" y="440267"/>
                </a:lnTo>
                <a:lnTo>
                  <a:pt x="0" y="440267"/>
                </a:lnTo>
                <a:lnTo>
                  <a:pt x="0" y="440267"/>
                </a:lnTo>
                <a:lnTo>
                  <a:pt x="0" y="440267"/>
                </a:lnTo>
                <a:lnTo>
                  <a:pt x="12700" y="482600"/>
                </a:lnTo>
                <a:lnTo>
                  <a:pt x="203200" y="325967"/>
                </a:lnTo>
                <a:lnTo>
                  <a:pt x="275167" y="186267"/>
                </a:lnTo>
                <a:lnTo>
                  <a:pt x="283633" y="71967"/>
                </a:lnTo>
                <a:lnTo>
                  <a:pt x="262467" y="16934"/>
                </a:lnTo>
                <a:lnTo>
                  <a:pt x="203200" y="0"/>
                </a:lnTo>
                <a:lnTo>
                  <a:pt x="131233" y="0"/>
                </a:lnTo>
                <a:close/>
              </a:path>
            </a:pathLst>
          </a:custGeom>
          <a:solidFill>
            <a:schemeClr val="accent6">
              <a:lumMod val="60000"/>
              <a:lumOff val="40000"/>
              <a:alpha val="0"/>
            </a:schemeClr>
          </a:solidFill>
          <a:ln w="9525">
            <a:solidFill>
              <a:schemeClr val="bg1">
                <a:lumMod val="65000"/>
              </a:schemeClr>
            </a:solidFill>
            <a:prstDash val="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103" name="Rectangle 102"/>
          <p:cNvSpPr/>
          <p:nvPr/>
        </p:nvSpPr>
        <p:spPr>
          <a:xfrm rot="20391004">
            <a:off x="2909746" y="3291251"/>
            <a:ext cx="185328" cy="224538"/>
          </a:xfrm>
          <a:custGeom>
            <a:avLst/>
            <a:gdLst/>
            <a:ahLst/>
            <a:cxnLst/>
            <a:rect l="l" t="t" r="r" b="b"/>
            <a:pathLst>
              <a:path w="147818" h="194016">
                <a:moveTo>
                  <a:pt x="31662" y="0"/>
                </a:moveTo>
                <a:lnTo>
                  <a:pt x="112925" y="0"/>
                </a:lnTo>
                <a:lnTo>
                  <a:pt x="112925" y="147453"/>
                </a:lnTo>
                <a:lnTo>
                  <a:pt x="147818" y="147453"/>
                </a:lnTo>
                <a:lnTo>
                  <a:pt x="147818" y="193172"/>
                </a:lnTo>
                <a:lnTo>
                  <a:pt x="112925" y="193172"/>
                </a:lnTo>
                <a:lnTo>
                  <a:pt x="112925" y="194016"/>
                </a:lnTo>
                <a:lnTo>
                  <a:pt x="31662" y="194016"/>
                </a:lnTo>
                <a:lnTo>
                  <a:pt x="31662" y="193172"/>
                </a:lnTo>
                <a:lnTo>
                  <a:pt x="0" y="193172"/>
                </a:lnTo>
                <a:lnTo>
                  <a:pt x="0" y="147453"/>
                </a:lnTo>
                <a:lnTo>
                  <a:pt x="31662" y="147453"/>
                </a:lnTo>
                <a:close/>
              </a:path>
            </a:pathLst>
          </a:custGeom>
          <a:solidFill>
            <a:schemeClr val="accent3">
              <a:lumMod val="60000"/>
              <a:lumOff val="40000"/>
            </a:schemeClr>
          </a:solidFill>
          <a:ln w="3175" cmpd="sng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105" name="Rectangle 102"/>
          <p:cNvSpPr/>
          <p:nvPr/>
        </p:nvSpPr>
        <p:spPr>
          <a:xfrm rot="20391004">
            <a:off x="4779682" y="3653795"/>
            <a:ext cx="185328" cy="224538"/>
          </a:xfrm>
          <a:custGeom>
            <a:avLst/>
            <a:gdLst/>
            <a:ahLst/>
            <a:cxnLst/>
            <a:rect l="l" t="t" r="r" b="b"/>
            <a:pathLst>
              <a:path w="147818" h="194016">
                <a:moveTo>
                  <a:pt x="31662" y="0"/>
                </a:moveTo>
                <a:lnTo>
                  <a:pt x="112925" y="0"/>
                </a:lnTo>
                <a:lnTo>
                  <a:pt x="112925" y="147453"/>
                </a:lnTo>
                <a:lnTo>
                  <a:pt x="147818" y="147453"/>
                </a:lnTo>
                <a:lnTo>
                  <a:pt x="147818" y="193172"/>
                </a:lnTo>
                <a:lnTo>
                  <a:pt x="112925" y="193172"/>
                </a:lnTo>
                <a:lnTo>
                  <a:pt x="112925" y="194016"/>
                </a:lnTo>
                <a:lnTo>
                  <a:pt x="31662" y="194016"/>
                </a:lnTo>
                <a:lnTo>
                  <a:pt x="31662" y="193172"/>
                </a:lnTo>
                <a:lnTo>
                  <a:pt x="0" y="193172"/>
                </a:lnTo>
                <a:lnTo>
                  <a:pt x="0" y="147453"/>
                </a:lnTo>
                <a:lnTo>
                  <a:pt x="31662" y="147453"/>
                </a:lnTo>
                <a:close/>
              </a:path>
            </a:pathLst>
          </a:custGeom>
          <a:solidFill>
            <a:schemeClr val="accent3">
              <a:lumMod val="60000"/>
              <a:lumOff val="40000"/>
            </a:schemeClr>
          </a:solidFill>
          <a:ln w="3175" cmpd="sng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5" name="Pentagon 4"/>
          <p:cNvSpPr/>
          <p:nvPr/>
        </p:nvSpPr>
        <p:spPr>
          <a:xfrm rot="4117223">
            <a:off x="1560699" y="1571719"/>
            <a:ext cx="224538" cy="100617"/>
          </a:xfrm>
          <a:prstGeom prst="homePlate">
            <a:avLst/>
          </a:prstGeom>
          <a:solidFill>
            <a:srgbClr val="008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22" name="Pentagon 21"/>
          <p:cNvSpPr/>
          <p:nvPr/>
        </p:nvSpPr>
        <p:spPr>
          <a:xfrm rot="13184127">
            <a:off x="1793324" y="1762647"/>
            <a:ext cx="267610" cy="97114"/>
          </a:xfrm>
          <a:prstGeom prst="homePlat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17" name="Arc 16"/>
          <p:cNvSpPr/>
          <p:nvPr/>
        </p:nvSpPr>
        <p:spPr>
          <a:xfrm rot="5400000">
            <a:off x="1397441" y="1809706"/>
            <a:ext cx="575613" cy="387605"/>
          </a:xfrm>
          <a:prstGeom prst="arc">
            <a:avLst>
              <a:gd name="adj1" fmla="val 19275184"/>
              <a:gd name="adj2" fmla="val 5760556"/>
            </a:avLst>
          </a:prstGeom>
          <a:noFill/>
          <a:ln>
            <a:solidFill>
              <a:schemeClr val="accent2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20" name="Rectangle 19"/>
          <p:cNvSpPr/>
          <p:nvPr/>
        </p:nvSpPr>
        <p:spPr>
          <a:xfrm rot="2433720">
            <a:off x="1979090" y="1607007"/>
            <a:ext cx="148611" cy="727057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32" name="Oval 31"/>
          <p:cNvSpPr/>
          <p:nvPr/>
        </p:nvSpPr>
        <p:spPr>
          <a:xfrm>
            <a:off x="1417140" y="824025"/>
            <a:ext cx="297183" cy="1189264"/>
          </a:xfrm>
          <a:custGeom>
            <a:avLst/>
            <a:gdLst/>
            <a:ahLst/>
            <a:cxnLst/>
            <a:rect l="l" t="t" r="r" b="b"/>
            <a:pathLst>
              <a:path w="237033" h="1027603">
                <a:moveTo>
                  <a:pt x="0" y="0"/>
                </a:moveTo>
                <a:lnTo>
                  <a:pt x="118532" y="0"/>
                </a:lnTo>
                <a:lnTo>
                  <a:pt x="118532" y="420780"/>
                </a:lnTo>
                <a:lnTo>
                  <a:pt x="126966" y="419077"/>
                </a:lnTo>
                <a:cubicBezTo>
                  <a:pt x="187754" y="419077"/>
                  <a:pt x="237033" y="468356"/>
                  <a:pt x="237033" y="529144"/>
                </a:cubicBezTo>
                <a:cubicBezTo>
                  <a:pt x="237033" y="589932"/>
                  <a:pt x="187754" y="639211"/>
                  <a:pt x="126966" y="639211"/>
                </a:cubicBezTo>
                <a:lnTo>
                  <a:pt x="118532" y="637508"/>
                </a:lnTo>
                <a:lnTo>
                  <a:pt x="118532" y="1027603"/>
                </a:lnTo>
                <a:lnTo>
                  <a:pt x="0" y="1027603"/>
                </a:lnTo>
                <a:close/>
              </a:path>
            </a:pathLst>
          </a:custGeom>
          <a:solidFill>
            <a:srgbClr val="C0504D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grpSp>
        <p:nvGrpSpPr>
          <p:cNvPr id="8" name="Group 7"/>
          <p:cNvGrpSpPr/>
          <p:nvPr/>
        </p:nvGrpSpPr>
        <p:grpSpPr>
          <a:xfrm>
            <a:off x="1884181" y="824045"/>
            <a:ext cx="514839" cy="690803"/>
            <a:chOff x="3365481" y="859384"/>
            <a:chExt cx="410636" cy="596900"/>
          </a:xfrm>
        </p:grpSpPr>
        <p:sp>
          <p:nvSpPr>
            <p:cNvPr id="7" name="Freeform 6"/>
            <p:cNvSpPr/>
            <p:nvPr/>
          </p:nvSpPr>
          <p:spPr>
            <a:xfrm>
              <a:off x="3492484" y="956753"/>
              <a:ext cx="283633" cy="482600"/>
            </a:xfrm>
            <a:custGeom>
              <a:avLst/>
              <a:gdLst>
                <a:gd name="connsiteX0" fmla="*/ 131233 w 283633"/>
                <a:gd name="connsiteY0" fmla="*/ 0 h 482600"/>
                <a:gd name="connsiteX1" fmla="*/ 93133 w 283633"/>
                <a:gd name="connsiteY1" fmla="*/ 63500 h 482600"/>
                <a:gd name="connsiteX2" fmla="*/ 93133 w 283633"/>
                <a:gd name="connsiteY2" fmla="*/ 165100 h 482600"/>
                <a:gd name="connsiteX3" fmla="*/ 139700 w 283633"/>
                <a:gd name="connsiteY3" fmla="*/ 254000 h 482600"/>
                <a:gd name="connsiteX4" fmla="*/ 165100 w 283633"/>
                <a:gd name="connsiteY4" fmla="*/ 287867 h 482600"/>
                <a:gd name="connsiteX5" fmla="*/ 131233 w 283633"/>
                <a:gd name="connsiteY5" fmla="*/ 338667 h 482600"/>
                <a:gd name="connsiteX6" fmla="*/ 0 w 283633"/>
                <a:gd name="connsiteY6" fmla="*/ 440267 h 482600"/>
                <a:gd name="connsiteX7" fmla="*/ 0 w 283633"/>
                <a:gd name="connsiteY7" fmla="*/ 440267 h 482600"/>
                <a:gd name="connsiteX8" fmla="*/ 0 w 283633"/>
                <a:gd name="connsiteY8" fmla="*/ 440267 h 482600"/>
                <a:gd name="connsiteX9" fmla="*/ 0 w 283633"/>
                <a:gd name="connsiteY9" fmla="*/ 440267 h 482600"/>
                <a:gd name="connsiteX10" fmla="*/ 12700 w 283633"/>
                <a:gd name="connsiteY10" fmla="*/ 482600 h 482600"/>
                <a:gd name="connsiteX11" fmla="*/ 203200 w 283633"/>
                <a:gd name="connsiteY11" fmla="*/ 325967 h 482600"/>
                <a:gd name="connsiteX12" fmla="*/ 275167 w 283633"/>
                <a:gd name="connsiteY12" fmla="*/ 186267 h 482600"/>
                <a:gd name="connsiteX13" fmla="*/ 283633 w 283633"/>
                <a:gd name="connsiteY13" fmla="*/ 71967 h 482600"/>
                <a:gd name="connsiteX14" fmla="*/ 262467 w 283633"/>
                <a:gd name="connsiteY14" fmla="*/ 16934 h 482600"/>
                <a:gd name="connsiteX15" fmla="*/ 203200 w 283633"/>
                <a:gd name="connsiteY15" fmla="*/ 0 h 482600"/>
                <a:gd name="connsiteX16" fmla="*/ 131233 w 283633"/>
                <a:gd name="connsiteY16" fmla="*/ 0 h 482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283633" h="482600">
                  <a:moveTo>
                    <a:pt x="131233" y="0"/>
                  </a:moveTo>
                  <a:lnTo>
                    <a:pt x="93133" y="63500"/>
                  </a:lnTo>
                  <a:lnTo>
                    <a:pt x="93133" y="165100"/>
                  </a:lnTo>
                  <a:lnTo>
                    <a:pt x="139700" y="254000"/>
                  </a:lnTo>
                  <a:lnTo>
                    <a:pt x="165100" y="287867"/>
                  </a:lnTo>
                  <a:lnTo>
                    <a:pt x="131233" y="3386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12700" y="482600"/>
                  </a:lnTo>
                  <a:lnTo>
                    <a:pt x="203200" y="325967"/>
                  </a:lnTo>
                  <a:lnTo>
                    <a:pt x="275167" y="186267"/>
                  </a:lnTo>
                  <a:lnTo>
                    <a:pt x="283633" y="71967"/>
                  </a:lnTo>
                  <a:lnTo>
                    <a:pt x="262467" y="16934"/>
                  </a:lnTo>
                  <a:lnTo>
                    <a:pt x="203200" y="0"/>
                  </a:lnTo>
                  <a:lnTo>
                    <a:pt x="131233" y="0"/>
                  </a:lnTo>
                  <a:close/>
                </a:path>
              </a:pathLst>
            </a:cu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  <p:sp>
          <p:nvSpPr>
            <p:cNvPr id="6" name="Freeform 5"/>
            <p:cNvSpPr/>
            <p:nvPr/>
          </p:nvSpPr>
          <p:spPr>
            <a:xfrm>
              <a:off x="3365481" y="859384"/>
              <a:ext cx="309033" cy="596900"/>
            </a:xfrm>
            <a:custGeom>
              <a:avLst/>
              <a:gdLst/>
              <a:ahLst/>
              <a:cxnLst/>
              <a:rect l="l" t="t" r="r" b="b"/>
              <a:pathLst>
                <a:path w="309033" h="596900">
                  <a:moveTo>
                    <a:pt x="118533" y="0"/>
                  </a:moveTo>
                  <a:lnTo>
                    <a:pt x="309033" y="63500"/>
                  </a:lnTo>
                  <a:lnTo>
                    <a:pt x="245533" y="194734"/>
                  </a:lnTo>
                  <a:lnTo>
                    <a:pt x="245533" y="300567"/>
                  </a:lnTo>
                  <a:lnTo>
                    <a:pt x="309033" y="414867"/>
                  </a:lnTo>
                  <a:lnTo>
                    <a:pt x="156633" y="596900"/>
                  </a:lnTo>
                  <a:lnTo>
                    <a:pt x="165100" y="508000"/>
                  </a:lnTo>
                  <a:lnTo>
                    <a:pt x="0" y="444500"/>
                  </a:lnTo>
                  <a:lnTo>
                    <a:pt x="357" y="421645"/>
                  </a:lnTo>
                  <a:lnTo>
                    <a:pt x="8450" y="423279"/>
                  </a:lnTo>
                  <a:cubicBezTo>
                    <a:pt x="73905" y="423279"/>
                    <a:pt x="126967" y="370217"/>
                    <a:pt x="126967" y="304762"/>
                  </a:cubicBezTo>
                  <a:cubicBezTo>
                    <a:pt x="126967" y="239307"/>
                    <a:pt x="73905" y="186245"/>
                    <a:pt x="8450" y="186245"/>
                  </a:cubicBezTo>
                  <a:lnTo>
                    <a:pt x="4021" y="187139"/>
                  </a:lnTo>
                  <a:lnTo>
                    <a:pt x="4233" y="173567"/>
                  </a:lnTo>
                  <a:close/>
                </a:path>
              </a:pathLst>
            </a:cu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2343311" y="1035619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SUMO</a:t>
            </a:r>
            <a:endParaRPr lang="en-US" sz="8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047734" y="672033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Ubc9</a:t>
            </a:r>
            <a:endParaRPr lang="en-US" sz="8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930995" y="1058947"/>
            <a:ext cx="5264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/>
              <a:t>Ubc9 binding site</a:t>
            </a:r>
            <a:endParaRPr lang="en-US" sz="800" b="1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1321601" y="1358050"/>
            <a:ext cx="270687" cy="78389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495552" y="1693720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1</a:t>
            </a:r>
            <a:endParaRPr lang="en-US" sz="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638997" y="1852511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2</a:t>
            </a:r>
            <a:endParaRPr lang="en-US" sz="800" b="1" dirty="0"/>
          </a:p>
        </p:txBody>
      </p:sp>
      <p:sp>
        <p:nvSpPr>
          <p:cNvPr id="24" name="Pentagon 23"/>
          <p:cNvSpPr/>
          <p:nvPr/>
        </p:nvSpPr>
        <p:spPr>
          <a:xfrm rot="3939206">
            <a:off x="3604660" y="1554929"/>
            <a:ext cx="224538" cy="100617"/>
          </a:xfrm>
          <a:prstGeom prst="homePlate">
            <a:avLst/>
          </a:prstGeom>
          <a:solidFill>
            <a:srgbClr val="008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25" name="Pentagon 24"/>
          <p:cNvSpPr/>
          <p:nvPr/>
        </p:nvSpPr>
        <p:spPr>
          <a:xfrm rot="13184127">
            <a:off x="3837285" y="1745857"/>
            <a:ext cx="267610" cy="97114"/>
          </a:xfrm>
          <a:prstGeom prst="homePlat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26" name="Arc 25"/>
          <p:cNvSpPr/>
          <p:nvPr/>
        </p:nvSpPr>
        <p:spPr>
          <a:xfrm rot="5400000">
            <a:off x="3441403" y="1792915"/>
            <a:ext cx="575613" cy="387605"/>
          </a:xfrm>
          <a:prstGeom prst="arc">
            <a:avLst>
              <a:gd name="adj1" fmla="val 19275184"/>
              <a:gd name="adj2" fmla="val 5760556"/>
            </a:avLst>
          </a:prstGeom>
          <a:noFill/>
          <a:ln>
            <a:solidFill>
              <a:schemeClr val="accent2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27" name="Rectangle 26"/>
          <p:cNvSpPr/>
          <p:nvPr/>
        </p:nvSpPr>
        <p:spPr>
          <a:xfrm rot="2433720">
            <a:off x="4023051" y="1590217"/>
            <a:ext cx="148611" cy="727057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28" name="Oval 31"/>
          <p:cNvSpPr/>
          <p:nvPr/>
        </p:nvSpPr>
        <p:spPr>
          <a:xfrm>
            <a:off x="3461101" y="807235"/>
            <a:ext cx="297183" cy="1189264"/>
          </a:xfrm>
          <a:custGeom>
            <a:avLst/>
            <a:gdLst/>
            <a:ahLst/>
            <a:cxnLst/>
            <a:rect l="l" t="t" r="r" b="b"/>
            <a:pathLst>
              <a:path w="237033" h="1027603">
                <a:moveTo>
                  <a:pt x="0" y="0"/>
                </a:moveTo>
                <a:lnTo>
                  <a:pt x="118532" y="0"/>
                </a:lnTo>
                <a:lnTo>
                  <a:pt x="118532" y="420780"/>
                </a:lnTo>
                <a:lnTo>
                  <a:pt x="126966" y="419077"/>
                </a:lnTo>
                <a:cubicBezTo>
                  <a:pt x="187754" y="419077"/>
                  <a:pt x="237033" y="468356"/>
                  <a:pt x="237033" y="529144"/>
                </a:cubicBezTo>
                <a:cubicBezTo>
                  <a:pt x="237033" y="589932"/>
                  <a:pt x="187754" y="639211"/>
                  <a:pt x="126966" y="639211"/>
                </a:cubicBezTo>
                <a:lnTo>
                  <a:pt x="118532" y="637508"/>
                </a:lnTo>
                <a:lnTo>
                  <a:pt x="118532" y="1027603"/>
                </a:lnTo>
                <a:lnTo>
                  <a:pt x="0" y="1027603"/>
                </a:lnTo>
                <a:close/>
              </a:path>
            </a:pathLst>
          </a:custGeom>
          <a:solidFill>
            <a:srgbClr val="C0504D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34" name="TextBox 33"/>
          <p:cNvSpPr txBox="1"/>
          <p:nvPr/>
        </p:nvSpPr>
        <p:spPr>
          <a:xfrm>
            <a:off x="3539513" y="1676930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1</a:t>
            </a:r>
            <a:endParaRPr lang="en-US" sz="8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3682962" y="1835721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2</a:t>
            </a:r>
            <a:endParaRPr lang="en-US" sz="800" b="1" dirty="0"/>
          </a:p>
        </p:txBody>
      </p:sp>
      <p:sp>
        <p:nvSpPr>
          <p:cNvPr id="36" name="Pentagon 35"/>
          <p:cNvSpPr/>
          <p:nvPr/>
        </p:nvSpPr>
        <p:spPr>
          <a:xfrm rot="4283238">
            <a:off x="5248961" y="1571719"/>
            <a:ext cx="224538" cy="100617"/>
          </a:xfrm>
          <a:prstGeom prst="homePlate">
            <a:avLst/>
          </a:prstGeom>
          <a:solidFill>
            <a:srgbClr val="008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37" name="Pentagon 36"/>
          <p:cNvSpPr/>
          <p:nvPr/>
        </p:nvSpPr>
        <p:spPr>
          <a:xfrm rot="13184127">
            <a:off x="5481585" y="1762647"/>
            <a:ext cx="267610" cy="97114"/>
          </a:xfrm>
          <a:prstGeom prst="homePlat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38" name="Arc 37"/>
          <p:cNvSpPr/>
          <p:nvPr/>
        </p:nvSpPr>
        <p:spPr>
          <a:xfrm rot="5400000">
            <a:off x="5085703" y="1809706"/>
            <a:ext cx="575613" cy="387605"/>
          </a:xfrm>
          <a:prstGeom prst="arc">
            <a:avLst>
              <a:gd name="adj1" fmla="val 19275184"/>
              <a:gd name="adj2" fmla="val 5760556"/>
            </a:avLst>
          </a:prstGeom>
          <a:noFill/>
          <a:ln>
            <a:solidFill>
              <a:schemeClr val="accent2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39" name="Rectangle 38"/>
          <p:cNvSpPr/>
          <p:nvPr/>
        </p:nvSpPr>
        <p:spPr>
          <a:xfrm rot="2433720">
            <a:off x="5667354" y="1607007"/>
            <a:ext cx="148611" cy="727057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40" name="Oval 31"/>
          <p:cNvSpPr/>
          <p:nvPr/>
        </p:nvSpPr>
        <p:spPr>
          <a:xfrm>
            <a:off x="5105401" y="824025"/>
            <a:ext cx="297183" cy="1189264"/>
          </a:xfrm>
          <a:custGeom>
            <a:avLst/>
            <a:gdLst/>
            <a:ahLst/>
            <a:cxnLst/>
            <a:rect l="l" t="t" r="r" b="b"/>
            <a:pathLst>
              <a:path w="237033" h="1027603">
                <a:moveTo>
                  <a:pt x="0" y="0"/>
                </a:moveTo>
                <a:lnTo>
                  <a:pt x="118532" y="0"/>
                </a:lnTo>
                <a:lnTo>
                  <a:pt x="118532" y="420780"/>
                </a:lnTo>
                <a:lnTo>
                  <a:pt x="126966" y="419077"/>
                </a:lnTo>
                <a:cubicBezTo>
                  <a:pt x="187754" y="419077"/>
                  <a:pt x="237033" y="468356"/>
                  <a:pt x="237033" y="529144"/>
                </a:cubicBezTo>
                <a:cubicBezTo>
                  <a:pt x="237033" y="589932"/>
                  <a:pt x="187754" y="639211"/>
                  <a:pt x="126966" y="639211"/>
                </a:cubicBezTo>
                <a:lnTo>
                  <a:pt x="118532" y="637508"/>
                </a:lnTo>
                <a:lnTo>
                  <a:pt x="118532" y="1027603"/>
                </a:lnTo>
                <a:lnTo>
                  <a:pt x="0" y="1027603"/>
                </a:lnTo>
                <a:close/>
              </a:path>
            </a:pathLst>
          </a:custGeom>
          <a:solidFill>
            <a:srgbClr val="C0504D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43" name="Freeform 42"/>
          <p:cNvSpPr/>
          <p:nvPr/>
        </p:nvSpPr>
        <p:spPr>
          <a:xfrm>
            <a:off x="5364991" y="1184724"/>
            <a:ext cx="355608" cy="558522"/>
          </a:xfrm>
          <a:custGeom>
            <a:avLst/>
            <a:gdLst>
              <a:gd name="connsiteX0" fmla="*/ 131233 w 283633"/>
              <a:gd name="connsiteY0" fmla="*/ 0 h 482600"/>
              <a:gd name="connsiteX1" fmla="*/ 93133 w 283633"/>
              <a:gd name="connsiteY1" fmla="*/ 63500 h 482600"/>
              <a:gd name="connsiteX2" fmla="*/ 93133 w 283633"/>
              <a:gd name="connsiteY2" fmla="*/ 165100 h 482600"/>
              <a:gd name="connsiteX3" fmla="*/ 139700 w 283633"/>
              <a:gd name="connsiteY3" fmla="*/ 254000 h 482600"/>
              <a:gd name="connsiteX4" fmla="*/ 165100 w 283633"/>
              <a:gd name="connsiteY4" fmla="*/ 287867 h 482600"/>
              <a:gd name="connsiteX5" fmla="*/ 131233 w 283633"/>
              <a:gd name="connsiteY5" fmla="*/ 338667 h 482600"/>
              <a:gd name="connsiteX6" fmla="*/ 0 w 283633"/>
              <a:gd name="connsiteY6" fmla="*/ 440267 h 482600"/>
              <a:gd name="connsiteX7" fmla="*/ 0 w 283633"/>
              <a:gd name="connsiteY7" fmla="*/ 440267 h 482600"/>
              <a:gd name="connsiteX8" fmla="*/ 0 w 283633"/>
              <a:gd name="connsiteY8" fmla="*/ 440267 h 482600"/>
              <a:gd name="connsiteX9" fmla="*/ 0 w 283633"/>
              <a:gd name="connsiteY9" fmla="*/ 440267 h 482600"/>
              <a:gd name="connsiteX10" fmla="*/ 12700 w 283633"/>
              <a:gd name="connsiteY10" fmla="*/ 482600 h 482600"/>
              <a:gd name="connsiteX11" fmla="*/ 203200 w 283633"/>
              <a:gd name="connsiteY11" fmla="*/ 325967 h 482600"/>
              <a:gd name="connsiteX12" fmla="*/ 275167 w 283633"/>
              <a:gd name="connsiteY12" fmla="*/ 186267 h 482600"/>
              <a:gd name="connsiteX13" fmla="*/ 283633 w 283633"/>
              <a:gd name="connsiteY13" fmla="*/ 71967 h 482600"/>
              <a:gd name="connsiteX14" fmla="*/ 262467 w 283633"/>
              <a:gd name="connsiteY14" fmla="*/ 16934 h 482600"/>
              <a:gd name="connsiteX15" fmla="*/ 203200 w 283633"/>
              <a:gd name="connsiteY15" fmla="*/ 0 h 482600"/>
              <a:gd name="connsiteX16" fmla="*/ 131233 w 283633"/>
              <a:gd name="connsiteY16" fmla="*/ 0 h 482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283633" h="482600">
                <a:moveTo>
                  <a:pt x="131233" y="0"/>
                </a:moveTo>
                <a:lnTo>
                  <a:pt x="93133" y="63500"/>
                </a:lnTo>
                <a:lnTo>
                  <a:pt x="93133" y="165100"/>
                </a:lnTo>
                <a:lnTo>
                  <a:pt x="139700" y="254000"/>
                </a:lnTo>
                <a:lnTo>
                  <a:pt x="165100" y="287867"/>
                </a:lnTo>
                <a:lnTo>
                  <a:pt x="131233" y="338667"/>
                </a:lnTo>
                <a:lnTo>
                  <a:pt x="0" y="440267"/>
                </a:lnTo>
                <a:lnTo>
                  <a:pt x="0" y="440267"/>
                </a:lnTo>
                <a:lnTo>
                  <a:pt x="0" y="440267"/>
                </a:lnTo>
                <a:lnTo>
                  <a:pt x="0" y="440267"/>
                </a:lnTo>
                <a:lnTo>
                  <a:pt x="12700" y="482600"/>
                </a:lnTo>
                <a:lnTo>
                  <a:pt x="203200" y="325967"/>
                </a:lnTo>
                <a:lnTo>
                  <a:pt x="275167" y="186267"/>
                </a:lnTo>
                <a:lnTo>
                  <a:pt x="283633" y="71967"/>
                </a:lnTo>
                <a:lnTo>
                  <a:pt x="262467" y="16934"/>
                </a:lnTo>
                <a:lnTo>
                  <a:pt x="203200" y="0"/>
                </a:lnTo>
                <a:lnTo>
                  <a:pt x="131233" y="0"/>
                </a:lnTo>
                <a:close/>
              </a:path>
            </a:pathLst>
          </a:cu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44" name="TextBox 43"/>
          <p:cNvSpPr txBox="1"/>
          <p:nvPr/>
        </p:nvSpPr>
        <p:spPr>
          <a:xfrm>
            <a:off x="5183813" y="1693720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1</a:t>
            </a:r>
            <a:endParaRPr lang="en-US" sz="8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5327262" y="1852511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2</a:t>
            </a:r>
            <a:endParaRPr lang="en-US" sz="800" b="1" dirty="0"/>
          </a:p>
        </p:txBody>
      </p:sp>
      <p:sp>
        <p:nvSpPr>
          <p:cNvPr id="47" name="Pentagon 46"/>
          <p:cNvSpPr/>
          <p:nvPr/>
        </p:nvSpPr>
        <p:spPr>
          <a:xfrm rot="13184127">
            <a:off x="3118566" y="3576004"/>
            <a:ext cx="267610" cy="97114"/>
          </a:xfrm>
          <a:prstGeom prst="homePlat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48" name="Arc 47"/>
          <p:cNvSpPr/>
          <p:nvPr/>
        </p:nvSpPr>
        <p:spPr>
          <a:xfrm rot="5400000">
            <a:off x="2722683" y="3623062"/>
            <a:ext cx="575613" cy="387605"/>
          </a:xfrm>
          <a:prstGeom prst="arc">
            <a:avLst>
              <a:gd name="adj1" fmla="val 19275184"/>
              <a:gd name="adj2" fmla="val 5760556"/>
            </a:avLst>
          </a:prstGeom>
          <a:noFill/>
          <a:ln>
            <a:solidFill>
              <a:schemeClr val="accent2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49" name="Rectangle 48"/>
          <p:cNvSpPr/>
          <p:nvPr/>
        </p:nvSpPr>
        <p:spPr>
          <a:xfrm rot="2433720">
            <a:off x="3304335" y="3420364"/>
            <a:ext cx="148611" cy="727057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50" name="Oval 31"/>
          <p:cNvSpPr/>
          <p:nvPr/>
        </p:nvSpPr>
        <p:spPr>
          <a:xfrm>
            <a:off x="2742382" y="2637382"/>
            <a:ext cx="297183" cy="1189264"/>
          </a:xfrm>
          <a:custGeom>
            <a:avLst/>
            <a:gdLst/>
            <a:ahLst/>
            <a:cxnLst/>
            <a:rect l="l" t="t" r="r" b="b"/>
            <a:pathLst>
              <a:path w="237033" h="1027603">
                <a:moveTo>
                  <a:pt x="0" y="0"/>
                </a:moveTo>
                <a:lnTo>
                  <a:pt x="118532" y="0"/>
                </a:lnTo>
                <a:lnTo>
                  <a:pt x="118532" y="420780"/>
                </a:lnTo>
                <a:lnTo>
                  <a:pt x="126966" y="419077"/>
                </a:lnTo>
                <a:cubicBezTo>
                  <a:pt x="187754" y="419077"/>
                  <a:pt x="237033" y="468356"/>
                  <a:pt x="237033" y="529144"/>
                </a:cubicBezTo>
                <a:cubicBezTo>
                  <a:pt x="237033" y="589932"/>
                  <a:pt x="187754" y="639211"/>
                  <a:pt x="126966" y="639211"/>
                </a:cubicBezTo>
                <a:lnTo>
                  <a:pt x="118532" y="637508"/>
                </a:lnTo>
                <a:lnTo>
                  <a:pt x="118532" y="1027603"/>
                </a:lnTo>
                <a:lnTo>
                  <a:pt x="0" y="1027603"/>
                </a:lnTo>
                <a:close/>
              </a:path>
            </a:pathLst>
          </a:custGeom>
          <a:solidFill>
            <a:srgbClr val="C0504D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grpSp>
        <p:nvGrpSpPr>
          <p:cNvPr id="51" name="Group 50"/>
          <p:cNvGrpSpPr/>
          <p:nvPr/>
        </p:nvGrpSpPr>
        <p:grpSpPr>
          <a:xfrm rot="21005863">
            <a:off x="2886858" y="2860254"/>
            <a:ext cx="507858" cy="695823"/>
            <a:chOff x="3365481" y="859384"/>
            <a:chExt cx="405068" cy="601236"/>
          </a:xfrm>
        </p:grpSpPr>
        <p:sp>
          <p:nvSpPr>
            <p:cNvPr id="53" name="Freeform 52"/>
            <p:cNvSpPr/>
            <p:nvPr/>
          </p:nvSpPr>
          <p:spPr>
            <a:xfrm>
              <a:off x="3486916" y="978021"/>
              <a:ext cx="283633" cy="482599"/>
            </a:xfrm>
            <a:custGeom>
              <a:avLst/>
              <a:gdLst>
                <a:gd name="connsiteX0" fmla="*/ 131233 w 283633"/>
                <a:gd name="connsiteY0" fmla="*/ 0 h 482600"/>
                <a:gd name="connsiteX1" fmla="*/ 93133 w 283633"/>
                <a:gd name="connsiteY1" fmla="*/ 63500 h 482600"/>
                <a:gd name="connsiteX2" fmla="*/ 93133 w 283633"/>
                <a:gd name="connsiteY2" fmla="*/ 165100 h 482600"/>
                <a:gd name="connsiteX3" fmla="*/ 139700 w 283633"/>
                <a:gd name="connsiteY3" fmla="*/ 254000 h 482600"/>
                <a:gd name="connsiteX4" fmla="*/ 165100 w 283633"/>
                <a:gd name="connsiteY4" fmla="*/ 287867 h 482600"/>
                <a:gd name="connsiteX5" fmla="*/ 131233 w 283633"/>
                <a:gd name="connsiteY5" fmla="*/ 338667 h 482600"/>
                <a:gd name="connsiteX6" fmla="*/ 0 w 283633"/>
                <a:gd name="connsiteY6" fmla="*/ 440267 h 482600"/>
                <a:gd name="connsiteX7" fmla="*/ 0 w 283633"/>
                <a:gd name="connsiteY7" fmla="*/ 440267 h 482600"/>
                <a:gd name="connsiteX8" fmla="*/ 0 w 283633"/>
                <a:gd name="connsiteY8" fmla="*/ 440267 h 482600"/>
                <a:gd name="connsiteX9" fmla="*/ 0 w 283633"/>
                <a:gd name="connsiteY9" fmla="*/ 440267 h 482600"/>
                <a:gd name="connsiteX10" fmla="*/ 12700 w 283633"/>
                <a:gd name="connsiteY10" fmla="*/ 482600 h 482600"/>
                <a:gd name="connsiteX11" fmla="*/ 203200 w 283633"/>
                <a:gd name="connsiteY11" fmla="*/ 325967 h 482600"/>
                <a:gd name="connsiteX12" fmla="*/ 275167 w 283633"/>
                <a:gd name="connsiteY12" fmla="*/ 186267 h 482600"/>
                <a:gd name="connsiteX13" fmla="*/ 283633 w 283633"/>
                <a:gd name="connsiteY13" fmla="*/ 71967 h 482600"/>
                <a:gd name="connsiteX14" fmla="*/ 262467 w 283633"/>
                <a:gd name="connsiteY14" fmla="*/ 16934 h 482600"/>
                <a:gd name="connsiteX15" fmla="*/ 203200 w 283633"/>
                <a:gd name="connsiteY15" fmla="*/ 0 h 482600"/>
                <a:gd name="connsiteX16" fmla="*/ 131233 w 283633"/>
                <a:gd name="connsiteY16" fmla="*/ 0 h 482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283633" h="482600">
                  <a:moveTo>
                    <a:pt x="131233" y="0"/>
                  </a:moveTo>
                  <a:lnTo>
                    <a:pt x="93133" y="63500"/>
                  </a:lnTo>
                  <a:lnTo>
                    <a:pt x="93133" y="165100"/>
                  </a:lnTo>
                  <a:lnTo>
                    <a:pt x="139700" y="254000"/>
                  </a:lnTo>
                  <a:lnTo>
                    <a:pt x="165100" y="287867"/>
                  </a:lnTo>
                  <a:lnTo>
                    <a:pt x="131233" y="3386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12700" y="482600"/>
                  </a:lnTo>
                  <a:lnTo>
                    <a:pt x="203200" y="325967"/>
                  </a:lnTo>
                  <a:lnTo>
                    <a:pt x="275167" y="186267"/>
                  </a:lnTo>
                  <a:lnTo>
                    <a:pt x="283633" y="71967"/>
                  </a:lnTo>
                  <a:lnTo>
                    <a:pt x="262467" y="16934"/>
                  </a:lnTo>
                  <a:lnTo>
                    <a:pt x="203200" y="0"/>
                  </a:lnTo>
                  <a:lnTo>
                    <a:pt x="131233" y="0"/>
                  </a:lnTo>
                  <a:close/>
                </a:path>
              </a:pathLst>
            </a:custGeom>
            <a:solidFill>
              <a:schemeClr val="accent6">
                <a:lumMod val="60000"/>
                <a:lumOff val="40000"/>
              </a:schemeClr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  <p:sp>
          <p:nvSpPr>
            <p:cNvPr id="52" name="Freeform 51"/>
            <p:cNvSpPr/>
            <p:nvPr/>
          </p:nvSpPr>
          <p:spPr>
            <a:xfrm>
              <a:off x="3365481" y="859384"/>
              <a:ext cx="309033" cy="596900"/>
            </a:xfrm>
            <a:custGeom>
              <a:avLst/>
              <a:gdLst/>
              <a:ahLst/>
              <a:cxnLst/>
              <a:rect l="l" t="t" r="r" b="b"/>
              <a:pathLst>
                <a:path w="309033" h="596900">
                  <a:moveTo>
                    <a:pt x="118533" y="0"/>
                  </a:moveTo>
                  <a:lnTo>
                    <a:pt x="309033" y="63500"/>
                  </a:lnTo>
                  <a:lnTo>
                    <a:pt x="245533" y="194734"/>
                  </a:lnTo>
                  <a:lnTo>
                    <a:pt x="245533" y="300567"/>
                  </a:lnTo>
                  <a:lnTo>
                    <a:pt x="309033" y="414867"/>
                  </a:lnTo>
                  <a:lnTo>
                    <a:pt x="156633" y="596900"/>
                  </a:lnTo>
                  <a:lnTo>
                    <a:pt x="165100" y="508000"/>
                  </a:lnTo>
                  <a:lnTo>
                    <a:pt x="0" y="444500"/>
                  </a:lnTo>
                  <a:lnTo>
                    <a:pt x="357" y="421645"/>
                  </a:lnTo>
                  <a:lnTo>
                    <a:pt x="8450" y="423279"/>
                  </a:lnTo>
                  <a:cubicBezTo>
                    <a:pt x="73905" y="423279"/>
                    <a:pt x="126967" y="370217"/>
                    <a:pt x="126967" y="304762"/>
                  </a:cubicBezTo>
                  <a:cubicBezTo>
                    <a:pt x="126967" y="239307"/>
                    <a:pt x="73905" y="186245"/>
                    <a:pt x="8450" y="186245"/>
                  </a:cubicBezTo>
                  <a:lnTo>
                    <a:pt x="4021" y="187139"/>
                  </a:lnTo>
                  <a:lnTo>
                    <a:pt x="4233" y="173567"/>
                  </a:lnTo>
                  <a:close/>
                </a:path>
              </a:pathLst>
            </a:custGeom>
            <a:solidFill>
              <a:schemeClr val="tx2">
                <a:lumMod val="60000"/>
                <a:lumOff val="40000"/>
              </a:schemeClr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</p:grpSp>
      <p:sp>
        <p:nvSpPr>
          <p:cNvPr id="54" name="TextBox 53"/>
          <p:cNvSpPr txBox="1"/>
          <p:nvPr/>
        </p:nvSpPr>
        <p:spPr>
          <a:xfrm>
            <a:off x="2820794" y="3507077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Mut1</a:t>
            </a:r>
            <a:endParaRPr lang="en-US" sz="80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2954717" y="3674661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2</a:t>
            </a:r>
            <a:endParaRPr lang="en-US" sz="800" b="1" dirty="0"/>
          </a:p>
        </p:txBody>
      </p:sp>
      <p:sp>
        <p:nvSpPr>
          <p:cNvPr id="57" name="Pentagon 56"/>
          <p:cNvSpPr/>
          <p:nvPr/>
        </p:nvSpPr>
        <p:spPr>
          <a:xfrm rot="13184127">
            <a:off x="4985634" y="3940235"/>
            <a:ext cx="267610" cy="97114"/>
          </a:xfrm>
          <a:prstGeom prst="homePlat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58" name="Arc 57"/>
          <p:cNvSpPr/>
          <p:nvPr/>
        </p:nvSpPr>
        <p:spPr>
          <a:xfrm rot="5400000">
            <a:off x="4589751" y="3987292"/>
            <a:ext cx="575613" cy="387605"/>
          </a:xfrm>
          <a:prstGeom prst="arc">
            <a:avLst>
              <a:gd name="adj1" fmla="val 19275184"/>
              <a:gd name="adj2" fmla="val 5760556"/>
            </a:avLst>
          </a:prstGeom>
          <a:noFill/>
          <a:ln>
            <a:solidFill>
              <a:schemeClr val="accent2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59" name="Rectangle 58"/>
          <p:cNvSpPr/>
          <p:nvPr/>
        </p:nvSpPr>
        <p:spPr>
          <a:xfrm rot="2433720">
            <a:off x="5171403" y="3784594"/>
            <a:ext cx="148611" cy="727057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60" name="Oval 31"/>
          <p:cNvSpPr/>
          <p:nvPr/>
        </p:nvSpPr>
        <p:spPr>
          <a:xfrm>
            <a:off x="4609450" y="3001611"/>
            <a:ext cx="297183" cy="1189264"/>
          </a:xfrm>
          <a:custGeom>
            <a:avLst/>
            <a:gdLst/>
            <a:ahLst/>
            <a:cxnLst/>
            <a:rect l="l" t="t" r="r" b="b"/>
            <a:pathLst>
              <a:path w="237033" h="1027603">
                <a:moveTo>
                  <a:pt x="0" y="0"/>
                </a:moveTo>
                <a:lnTo>
                  <a:pt x="118532" y="0"/>
                </a:lnTo>
                <a:lnTo>
                  <a:pt x="118532" y="420780"/>
                </a:lnTo>
                <a:lnTo>
                  <a:pt x="126966" y="419077"/>
                </a:lnTo>
                <a:cubicBezTo>
                  <a:pt x="187754" y="419077"/>
                  <a:pt x="237033" y="468356"/>
                  <a:pt x="237033" y="529144"/>
                </a:cubicBezTo>
                <a:cubicBezTo>
                  <a:pt x="237033" y="589932"/>
                  <a:pt x="187754" y="639211"/>
                  <a:pt x="126966" y="639211"/>
                </a:cubicBezTo>
                <a:lnTo>
                  <a:pt x="118532" y="637508"/>
                </a:lnTo>
                <a:lnTo>
                  <a:pt x="118532" y="1027603"/>
                </a:lnTo>
                <a:lnTo>
                  <a:pt x="0" y="1027603"/>
                </a:lnTo>
                <a:close/>
              </a:path>
            </a:pathLst>
          </a:custGeom>
          <a:solidFill>
            <a:srgbClr val="C0504D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63" name="Freeform 62"/>
          <p:cNvSpPr/>
          <p:nvPr/>
        </p:nvSpPr>
        <p:spPr>
          <a:xfrm>
            <a:off x="5020728" y="3410410"/>
            <a:ext cx="355608" cy="558522"/>
          </a:xfrm>
          <a:custGeom>
            <a:avLst/>
            <a:gdLst>
              <a:gd name="connsiteX0" fmla="*/ 131233 w 283633"/>
              <a:gd name="connsiteY0" fmla="*/ 0 h 482600"/>
              <a:gd name="connsiteX1" fmla="*/ 93133 w 283633"/>
              <a:gd name="connsiteY1" fmla="*/ 63500 h 482600"/>
              <a:gd name="connsiteX2" fmla="*/ 93133 w 283633"/>
              <a:gd name="connsiteY2" fmla="*/ 165100 h 482600"/>
              <a:gd name="connsiteX3" fmla="*/ 139700 w 283633"/>
              <a:gd name="connsiteY3" fmla="*/ 254000 h 482600"/>
              <a:gd name="connsiteX4" fmla="*/ 165100 w 283633"/>
              <a:gd name="connsiteY4" fmla="*/ 287867 h 482600"/>
              <a:gd name="connsiteX5" fmla="*/ 131233 w 283633"/>
              <a:gd name="connsiteY5" fmla="*/ 338667 h 482600"/>
              <a:gd name="connsiteX6" fmla="*/ 0 w 283633"/>
              <a:gd name="connsiteY6" fmla="*/ 440267 h 482600"/>
              <a:gd name="connsiteX7" fmla="*/ 0 w 283633"/>
              <a:gd name="connsiteY7" fmla="*/ 440267 h 482600"/>
              <a:gd name="connsiteX8" fmla="*/ 0 w 283633"/>
              <a:gd name="connsiteY8" fmla="*/ 440267 h 482600"/>
              <a:gd name="connsiteX9" fmla="*/ 0 w 283633"/>
              <a:gd name="connsiteY9" fmla="*/ 440267 h 482600"/>
              <a:gd name="connsiteX10" fmla="*/ 12700 w 283633"/>
              <a:gd name="connsiteY10" fmla="*/ 482600 h 482600"/>
              <a:gd name="connsiteX11" fmla="*/ 203200 w 283633"/>
              <a:gd name="connsiteY11" fmla="*/ 325967 h 482600"/>
              <a:gd name="connsiteX12" fmla="*/ 275167 w 283633"/>
              <a:gd name="connsiteY12" fmla="*/ 186267 h 482600"/>
              <a:gd name="connsiteX13" fmla="*/ 283633 w 283633"/>
              <a:gd name="connsiteY13" fmla="*/ 71967 h 482600"/>
              <a:gd name="connsiteX14" fmla="*/ 262467 w 283633"/>
              <a:gd name="connsiteY14" fmla="*/ 16934 h 482600"/>
              <a:gd name="connsiteX15" fmla="*/ 203200 w 283633"/>
              <a:gd name="connsiteY15" fmla="*/ 0 h 482600"/>
              <a:gd name="connsiteX16" fmla="*/ 131233 w 283633"/>
              <a:gd name="connsiteY16" fmla="*/ 0 h 482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283633" h="482600">
                <a:moveTo>
                  <a:pt x="131233" y="0"/>
                </a:moveTo>
                <a:lnTo>
                  <a:pt x="93133" y="63500"/>
                </a:lnTo>
                <a:lnTo>
                  <a:pt x="93133" y="165100"/>
                </a:lnTo>
                <a:lnTo>
                  <a:pt x="139700" y="254000"/>
                </a:lnTo>
                <a:lnTo>
                  <a:pt x="165100" y="287867"/>
                </a:lnTo>
                <a:lnTo>
                  <a:pt x="131233" y="338667"/>
                </a:lnTo>
                <a:lnTo>
                  <a:pt x="0" y="440267"/>
                </a:lnTo>
                <a:lnTo>
                  <a:pt x="0" y="440267"/>
                </a:lnTo>
                <a:lnTo>
                  <a:pt x="0" y="440267"/>
                </a:lnTo>
                <a:lnTo>
                  <a:pt x="0" y="440267"/>
                </a:lnTo>
                <a:lnTo>
                  <a:pt x="12700" y="482600"/>
                </a:lnTo>
                <a:lnTo>
                  <a:pt x="203200" y="325967"/>
                </a:lnTo>
                <a:lnTo>
                  <a:pt x="275167" y="186267"/>
                </a:lnTo>
                <a:lnTo>
                  <a:pt x="283633" y="71967"/>
                </a:lnTo>
                <a:lnTo>
                  <a:pt x="262467" y="16934"/>
                </a:lnTo>
                <a:lnTo>
                  <a:pt x="203200" y="0"/>
                </a:lnTo>
                <a:lnTo>
                  <a:pt x="131233" y="0"/>
                </a:lnTo>
                <a:close/>
              </a:path>
            </a:pathLst>
          </a:cu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64" name="TextBox 63"/>
          <p:cNvSpPr txBox="1"/>
          <p:nvPr/>
        </p:nvSpPr>
        <p:spPr>
          <a:xfrm>
            <a:off x="4687862" y="3871307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Mut1</a:t>
            </a:r>
            <a:endParaRPr lang="en-US" sz="800" b="1" dirty="0"/>
          </a:p>
        </p:txBody>
      </p:sp>
      <p:sp>
        <p:nvSpPr>
          <p:cNvPr id="65" name="TextBox 64"/>
          <p:cNvSpPr txBox="1"/>
          <p:nvPr/>
        </p:nvSpPr>
        <p:spPr>
          <a:xfrm>
            <a:off x="4821785" y="4038890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2</a:t>
            </a:r>
            <a:endParaRPr lang="en-US" sz="800" b="1" dirty="0"/>
          </a:p>
        </p:txBody>
      </p:sp>
      <p:sp>
        <p:nvSpPr>
          <p:cNvPr id="66" name="Pentagon 65"/>
          <p:cNvSpPr/>
          <p:nvPr/>
        </p:nvSpPr>
        <p:spPr>
          <a:xfrm rot="4236854">
            <a:off x="1828991" y="5371368"/>
            <a:ext cx="224538" cy="100617"/>
          </a:xfrm>
          <a:prstGeom prst="homePlate">
            <a:avLst/>
          </a:prstGeom>
          <a:solidFill>
            <a:srgbClr val="008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67" name="Pentagon 66"/>
          <p:cNvSpPr/>
          <p:nvPr/>
        </p:nvSpPr>
        <p:spPr>
          <a:xfrm rot="13184127">
            <a:off x="2061616" y="5562297"/>
            <a:ext cx="267610" cy="97114"/>
          </a:xfrm>
          <a:prstGeom prst="homePlat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68" name="Arc 67"/>
          <p:cNvSpPr/>
          <p:nvPr/>
        </p:nvSpPr>
        <p:spPr>
          <a:xfrm rot="5400000">
            <a:off x="1665733" y="5609354"/>
            <a:ext cx="575613" cy="387605"/>
          </a:xfrm>
          <a:prstGeom prst="arc">
            <a:avLst>
              <a:gd name="adj1" fmla="val 19275184"/>
              <a:gd name="adj2" fmla="val 5760556"/>
            </a:avLst>
          </a:prstGeom>
          <a:noFill/>
          <a:ln>
            <a:solidFill>
              <a:schemeClr val="accent2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69" name="Rectangle 68"/>
          <p:cNvSpPr/>
          <p:nvPr/>
        </p:nvSpPr>
        <p:spPr>
          <a:xfrm rot="2433720">
            <a:off x="2247385" y="5406657"/>
            <a:ext cx="148611" cy="727057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grpSp>
        <p:nvGrpSpPr>
          <p:cNvPr id="71" name="Group 70"/>
          <p:cNvGrpSpPr/>
          <p:nvPr/>
        </p:nvGrpSpPr>
        <p:grpSpPr>
          <a:xfrm>
            <a:off x="2397261" y="4454832"/>
            <a:ext cx="514563" cy="705501"/>
            <a:chOff x="3365481" y="859384"/>
            <a:chExt cx="410415" cy="609600"/>
          </a:xfrm>
        </p:grpSpPr>
        <p:sp>
          <p:nvSpPr>
            <p:cNvPr id="73" name="Freeform 72"/>
            <p:cNvSpPr/>
            <p:nvPr/>
          </p:nvSpPr>
          <p:spPr>
            <a:xfrm>
              <a:off x="3492263" y="986384"/>
              <a:ext cx="283633" cy="482600"/>
            </a:xfrm>
            <a:custGeom>
              <a:avLst/>
              <a:gdLst>
                <a:gd name="connsiteX0" fmla="*/ 131233 w 283633"/>
                <a:gd name="connsiteY0" fmla="*/ 0 h 482600"/>
                <a:gd name="connsiteX1" fmla="*/ 93133 w 283633"/>
                <a:gd name="connsiteY1" fmla="*/ 63500 h 482600"/>
                <a:gd name="connsiteX2" fmla="*/ 93133 w 283633"/>
                <a:gd name="connsiteY2" fmla="*/ 165100 h 482600"/>
                <a:gd name="connsiteX3" fmla="*/ 139700 w 283633"/>
                <a:gd name="connsiteY3" fmla="*/ 254000 h 482600"/>
                <a:gd name="connsiteX4" fmla="*/ 165100 w 283633"/>
                <a:gd name="connsiteY4" fmla="*/ 287867 h 482600"/>
                <a:gd name="connsiteX5" fmla="*/ 131233 w 283633"/>
                <a:gd name="connsiteY5" fmla="*/ 338667 h 482600"/>
                <a:gd name="connsiteX6" fmla="*/ 0 w 283633"/>
                <a:gd name="connsiteY6" fmla="*/ 440267 h 482600"/>
                <a:gd name="connsiteX7" fmla="*/ 0 w 283633"/>
                <a:gd name="connsiteY7" fmla="*/ 440267 h 482600"/>
                <a:gd name="connsiteX8" fmla="*/ 0 w 283633"/>
                <a:gd name="connsiteY8" fmla="*/ 440267 h 482600"/>
                <a:gd name="connsiteX9" fmla="*/ 0 w 283633"/>
                <a:gd name="connsiteY9" fmla="*/ 440267 h 482600"/>
                <a:gd name="connsiteX10" fmla="*/ 12700 w 283633"/>
                <a:gd name="connsiteY10" fmla="*/ 482600 h 482600"/>
                <a:gd name="connsiteX11" fmla="*/ 203200 w 283633"/>
                <a:gd name="connsiteY11" fmla="*/ 325967 h 482600"/>
                <a:gd name="connsiteX12" fmla="*/ 275167 w 283633"/>
                <a:gd name="connsiteY12" fmla="*/ 186267 h 482600"/>
                <a:gd name="connsiteX13" fmla="*/ 283633 w 283633"/>
                <a:gd name="connsiteY13" fmla="*/ 71967 h 482600"/>
                <a:gd name="connsiteX14" fmla="*/ 262467 w 283633"/>
                <a:gd name="connsiteY14" fmla="*/ 16934 h 482600"/>
                <a:gd name="connsiteX15" fmla="*/ 203200 w 283633"/>
                <a:gd name="connsiteY15" fmla="*/ 0 h 482600"/>
                <a:gd name="connsiteX16" fmla="*/ 131233 w 283633"/>
                <a:gd name="connsiteY16" fmla="*/ 0 h 482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283633" h="482600">
                  <a:moveTo>
                    <a:pt x="131233" y="0"/>
                  </a:moveTo>
                  <a:lnTo>
                    <a:pt x="93133" y="63500"/>
                  </a:lnTo>
                  <a:lnTo>
                    <a:pt x="93133" y="165100"/>
                  </a:lnTo>
                  <a:lnTo>
                    <a:pt x="139700" y="254000"/>
                  </a:lnTo>
                  <a:lnTo>
                    <a:pt x="165100" y="287867"/>
                  </a:lnTo>
                  <a:lnTo>
                    <a:pt x="131233" y="3386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12700" y="482600"/>
                  </a:lnTo>
                  <a:lnTo>
                    <a:pt x="203200" y="325967"/>
                  </a:lnTo>
                  <a:lnTo>
                    <a:pt x="275167" y="186267"/>
                  </a:lnTo>
                  <a:lnTo>
                    <a:pt x="283633" y="71967"/>
                  </a:lnTo>
                  <a:lnTo>
                    <a:pt x="262467" y="16934"/>
                  </a:lnTo>
                  <a:lnTo>
                    <a:pt x="203200" y="0"/>
                  </a:lnTo>
                  <a:lnTo>
                    <a:pt x="131233" y="0"/>
                  </a:lnTo>
                  <a:close/>
                </a:path>
              </a:pathLst>
            </a:cu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  <p:sp>
          <p:nvSpPr>
            <p:cNvPr id="72" name="Freeform 71"/>
            <p:cNvSpPr/>
            <p:nvPr/>
          </p:nvSpPr>
          <p:spPr>
            <a:xfrm>
              <a:off x="3365481" y="859384"/>
              <a:ext cx="309033" cy="596900"/>
            </a:xfrm>
            <a:custGeom>
              <a:avLst/>
              <a:gdLst/>
              <a:ahLst/>
              <a:cxnLst/>
              <a:rect l="l" t="t" r="r" b="b"/>
              <a:pathLst>
                <a:path w="309033" h="596900">
                  <a:moveTo>
                    <a:pt x="118533" y="0"/>
                  </a:moveTo>
                  <a:lnTo>
                    <a:pt x="309033" y="63500"/>
                  </a:lnTo>
                  <a:lnTo>
                    <a:pt x="245533" y="194734"/>
                  </a:lnTo>
                  <a:lnTo>
                    <a:pt x="245533" y="300567"/>
                  </a:lnTo>
                  <a:lnTo>
                    <a:pt x="309033" y="414867"/>
                  </a:lnTo>
                  <a:lnTo>
                    <a:pt x="156633" y="596900"/>
                  </a:lnTo>
                  <a:lnTo>
                    <a:pt x="165100" y="508000"/>
                  </a:lnTo>
                  <a:lnTo>
                    <a:pt x="0" y="444500"/>
                  </a:lnTo>
                  <a:lnTo>
                    <a:pt x="357" y="421645"/>
                  </a:lnTo>
                  <a:lnTo>
                    <a:pt x="8450" y="423279"/>
                  </a:lnTo>
                  <a:cubicBezTo>
                    <a:pt x="73905" y="423279"/>
                    <a:pt x="126967" y="370217"/>
                    <a:pt x="126967" y="304762"/>
                  </a:cubicBezTo>
                  <a:cubicBezTo>
                    <a:pt x="126967" y="239307"/>
                    <a:pt x="73905" y="186245"/>
                    <a:pt x="8450" y="186245"/>
                  </a:cubicBezTo>
                  <a:lnTo>
                    <a:pt x="4021" y="187139"/>
                  </a:lnTo>
                  <a:lnTo>
                    <a:pt x="4233" y="173567"/>
                  </a:lnTo>
                  <a:close/>
                </a:path>
              </a:pathLst>
            </a:cu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</p:grpSp>
      <p:sp>
        <p:nvSpPr>
          <p:cNvPr id="74" name="TextBox 73"/>
          <p:cNvSpPr txBox="1"/>
          <p:nvPr/>
        </p:nvSpPr>
        <p:spPr>
          <a:xfrm>
            <a:off x="1763844" y="5493369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1</a:t>
            </a:r>
            <a:endParaRPr lang="en-US" sz="800" b="1" dirty="0"/>
          </a:p>
        </p:txBody>
      </p:sp>
      <p:sp>
        <p:nvSpPr>
          <p:cNvPr id="75" name="TextBox 74"/>
          <p:cNvSpPr txBox="1"/>
          <p:nvPr/>
        </p:nvSpPr>
        <p:spPr>
          <a:xfrm>
            <a:off x="1897767" y="5660952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2</a:t>
            </a:r>
            <a:endParaRPr lang="en-US" sz="800" b="1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2858145" y="1515143"/>
            <a:ext cx="456659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>
            <a:off x="4388563" y="1498056"/>
            <a:ext cx="456659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/>
          <p:nvPr/>
        </p:nvCxnSpPr>
        <p:spPr>
          <a:xfrm>
            <a:off x="2096484" y="2387221"/>
            <a:ext cx="500229" cy="64822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>
            <a:off x="3923010" y="3507078"/>
            <a:ext cx="465550" cy="5995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>
            <a:off x="1606995" y="2529301"/>
            <a:ext cx="156846" cy="189036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Pentagon 81"/>
          <p:cNvSpPr/>
          <p:nvPr/>
        </p:nvSpPr>
        <p:spPr>
          <a:xfrm rot="4236854">
            <a:off x="3720056" y="5798159"/>
            <a:ext cx="224538" cy="100617"/>
          </a:xfrm>
          <a:prstGeom prst="homePlate">
            <a:avLst/>
          </a:prstGeom>
          <a:solidFill>
            <a:srgbClr val="008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83" name="Pentagon 82"/>
          <p:cNvSpPr/>
          <p:nvPr/>
        </p:nvSpPr>
        <p:spPr>
          <a:xfrm rot="13184127">
            <a:off x="3952681" y="5989088"/>
            <a:ext cx="267610" cy="97114"/>
          </a:xfrm>
          <a:prstGeom prst="homePlat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84" name="Arc 83"/>
          <p:cNvSpPr/>
          <p:nvPr/>
        </p:nvSpPr>
        <p:spPr>
          <a:xfrm rot="5400000">
            <a:off x="3556795" y="6036145"/>
            <a:ext cx="575613" cy="387605"/>
          </a:xfrm>
          <a:prstGeom prst="arc">
            <a:avLst>
              <a:gd name="adj1" fmla="val 19275184"/>
              <a:gd name="adj2" fmla="val 5760556"/>
            </a:avLst>
          </a:prstGeom>
          <a:noFill/>
          <a:ln>
            <a:solidFill>
              <a:schemeClr val="accent2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85" name="Rectangle 84"/>
          <p:cNvSpPr/>
          <p:nvPr/>
        </p:nvSpPr>
        <p:spPr>
          <a:xfrm rot="2433720">
            <a:off x="4138450" y="5833448"/>
            <a:ext cx="148611" cy="727057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sp>
        <p:nvSpPr>
          <p:cNvPr id="90" name="TextBox 89"/>
          <p:cNvSpPr txBox="1"/>
          <p:nvPr/>
        </p:nvSpPr>
        <p:spPr>
          <a:xfrm>
            <a:off x="3654909" y="5920161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1</a:t>
            </a:r>
            <a:endParaRPr lang="en-US" sz="800" b="1" dirty="0"/>
          </a:p>
        </p:txBody>
      </p:sp>
      <p:sp>
        <p:nvSpPr>
          <p:cNvPr id="91" name="TextBox 90"/>
          <p:cNvSpPr txBox="1"/>
          <p:nvPr/>
        </p:nvSpPr>
        <p:spPr>
          <a:xfrm>
            <a:off x="3788832" y="6087743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2</a:t>
            </a:r>
            <a:endParaRPr lang="en-US" sz="800" b="1" dirty="0"/>
          </a:p>
        </p:txBody>
      </p:sp>
      <p:cxnSp>
        <p:nvCxnSpPr>
          <p:cNvPr id="97" name="Straight Arrow Connector 96"/>
          <p:cNvCxnSpPr/>
          <p:nvPr/>
        </p:nvCxnSpPr>
        <p:spPr>
          <a:xfrm>
            <a:off x="2768163" y="5546651"/>
            <a:ext cx="586511" cy="11191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99" name="Group 98"/>
          <p:cNvGrpSpPr/>
          <p:nvPr/>
        </p:nvGrpSpPr>
        <p:grpSpPr>
          <a:xfrm>
            <a:off x="3605916" y="1072663"/>
            <a:ext cx="514839" cy="690803"/>
            <a:chOff x="3365481" y="859384"/>
            <a:chExt cx="410636" cy="596900"/>
          </a:xfrm>
        </p:grpSpPr>
        <p:sp>
          <p:nvSpPr>
            <p:cNvPr id="100" name="Freeform 99"/>
            <p:cNvSpPr/>
            <p:nvPr/>
          </p:nvSpPr>
          <p:spPr>
            <a:xfrm>
              <a:off x="3492484" y="956753"/>
              <a:ext cx="283633" cy="482600"/>
            </a:xfrm>
            <a:custGeom>
              <a:avLst/>
              <a:gdLst>
                <a:gd name="connsiteX0" fmla="*/ 131233 w 283633"/>
                <a:gd name="connsiteY0" fmla="*/ 0 h 482600"/>
                <a:gd name="connsiteX1" fmla="*/ 93133 w 283633"/>
                <a:gd name="connsiteY1" fmla="*/ 63500 h 482600"/>
                <a:gd name="connsiteX2" fmla="*/ 93133 w 283633"/>
                <a:gd name="connsiteY2" fmla="*/ 165100 h 482600"/>
                <a:gd name="connsiteX3" fmla="*/ 139700 w 283633"/>
                <a:gd name="connsiteY3" fmla="*/ 254000 h 482600"/>
                <a:gd name="connsiteX4" fmla="*/ 165100 w 283633"/>
                <a:gd name="connsiteY4" fmla="*/ 287867 h 482600"/>
                <a:gd name="connsiteX5" fmla="*/ 131233 w 283633"/>
                <a:gd name="connsiteY5" fmla="*/ 338667 h 482600"/>
                <a:gd name="connsiteX6" fmla="*/ 0 w 283633"/>
                <a:gd name="connsiteY6" fmla="*/ 440267 h 482600"/>
                <a:gd name="connsiteX7" fmla="*/ 0 w 283633"/>
                <a:gd name="connsiteY7" fmla="*/ 440267 h 482600"/>
                <a:gd name="connsiteX8" fmla="*/ 0 w 283633"/>
                <a:gd name="connsiteY8" fmla="*/ 440267 h 482600"/>
                <a:gd name="connsiteX9" fmla="*/ 0 w 283633"/>
                <a:gd name="connsiteY9" fmla="*/ 440267 h 482600"/>
                <a:gd name="connsiteX10" fmla="*/ 12700 w 283633"/>
                <a:gd name="connsiteY10" fmla="*/ 482600 h 482600"/>
                <a:gd name="connsiteX11" fmla="*/ 203200 w 283633"/>
                <a:gd name="connsiteY11" fmla="*/ 325967 h 482600"/>
                <a:gd name="connsiteX12" fmla="*/ 275167 w 283633"/>
                <a:gd name="connsiteY12" fmla="*/ 186267 h 482600"/>
                <a:gd name="connsiteX13" fmla="*/ 283633 w 283633"/>
                <a:gd name="connsiteY13" fmla="*/ 71967 h 482600"/>
                <a:gd name="connsiteX14" fmla="*/ 262467 w 283633"/>
                <a:gd name="connsiteY14" fmla="*/ 16934 h 482600"/>
                <a:gd name="connsiteX15" fmla="*/ 203200 w 283633"/>
                <a:gd name="connsiteY15" fmla="*/ 0 h 482600"/>
                <a:gd name="connsiteX16" fmla="*/ 131233 w 283633"/>
                <a:gd name="connsiteY16" fmla="*/ 0 h 482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283633" h="482600">
                  <a:moveTo>
                    <a:pt x="131233" y="0"/>
                  </a:moveTo>
                  <a:lnTo>
                    <a:pt x="93133" y="63500"/>
                  </a:lnTo>
                  <a:lnTo>
                    <a:pt x="93133" y="165100"/>
                  </a:lnTo>
                  <a:lnTo>
                    <a:pt x="139700" y="254000"/>
                  </a:lnTo>
                  <a:lnTo>
                    <a:pt x="165100" y="287867"/>
                  </a:lnTo>
                  <a:lnTo>
                    <a:pt x="131233" y="3386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12700" y="482600"/>
                  </a:lnTo>
                  <a:lnTo>
                    <a:pt x="203200" y="325967"/>
                  </a:lnTo>
                  <a:lnTo>
                    <a:pt x="275167" y="186267"/>
                  </a:lnTo>
                  <a:lnTo>
                    <a:pt x="283633" y="71967"/>
                  </a:lnTo>
                  <a:lnTo>
                    <a:pt x="262467" y="16934"/>
                  </a:lnTo>
                  <a:lnTo>
                    <a:pt x="203200" y="0"/>
                  </a:lnTo>
                  <a:lnTo>
                    <a:pt x="131233" y="0"/>
                  </a:lnTo>
                  <a:close/>
                </a:path>
              </a:pathLst>
            </a:cu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  <p:sp>
          <p:nvSpPr>
            <p:cNvPr id="101" name="Freeform 100"/>
            <p:cNvSpPr/>
            <p:nvPr/>
          </p:nvSpPr>
          <p:spPr>
            <a:xfrm>
              <a:off x="3365481" y="859384"/>
              <a:ext cx="309033" cy="596900"/>
            </a:xfrm>
            <a:custGeom>
              <a:avLst/>
              <a:gdLst/>
              <a:ahLst/>
              <a:cxnLst/>
              <a:rect l="l" t="t" r="r" b="b"/>
              <a:pathLst>
                <a:path w="309033" h="596900">
                  <a:moveTo>
                    <a:pt x="118533" y="0"/>
                  </a:moveTo>
                  <a:lnTo>
                    <a:pt x="309033" y="63500"/>
                  </a:lnTo>
                  <a:lnTo>
                    <a:pt x="245533" y="194734"/>
                  </a:lnTo>
                  <a:lnTo>
                    <a:pt x="245533" y="300567"/>
                  </a:lnTo>
                  <a:lnTo>
                    <a:pt x="309033" y="414867"/>
                  </a:lnTo>
                  <a:lnTo>
                    <a:pt x="156633" y="596900"/>
                  </a:lnTo>
                  <a:lnTo>
                    <a:pt x="165100" y="508000"/>
                  </a:lnTo>
                  <a:lnTo>
                    <a:pt x="0" y="444500"/>
                  </a:lnTo>
                  <a:lnTo>
                    <a:pt x="357" y="421645"/>
                  </a:lnTo>
                  <a:lnTo>
                    <a:pt x="8450" y="423279"/>
                  </a:lnTo>
                  <a:cubicBezTo>
                    <a:pt x="73905" y="423279"/>
                    <a:pt x="126967" y="370217"/>
                    <a:pt x="126967" y="304762"/>
                  </a:cubicBezTo>
                  <a:cubicBezTo>
                    <a:pt x="126967" y="239307"/>
                    <a:pt x="73905" y="186245"/>
                    <a:pt x="8450" y="186245"/>
                  </a:cubicBezTo>
                  <a:lnTo>
                    <a:pt x="4021" y="187139"/>
                  </a:lnTo>
                  <a:lnTo>
                    <a:pt x="4233" y="173567"/>
                  </a:lnTo>
                  <a:close/>
                </a:path>
              </a:pathLst>
            </a:cu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</p:grpSp>
      <p:grpSp>
        <p:nvGrpSpPr>
          <p:cNvPr id="106" name="Group 105"/>
          <p:cNvGrpSpPr/>
          <p:nvPr/>
        </p:nvGrpSpPr>
        <p:grpSpPr>
          <a:xfrm>
            <a:off x="2890118" y="2888471"/>
            <a:ext cx="514561" cy="705501"/>
            <a:chOff x="3365481" y="859384"/>
            <a:chExt cx="410413" cy="609600"/>
          </a:xfrm>
        </p:grpSpPr>
        <p:sp>
          <p:nvSpPr>
            <p:cNvPr id="108" name="Freeform 107"/>
            <p:cNvSpPr/>
            <p:nvPr/>
          </p:nvSpPr>
          <p:spPr>
            <a:xfrm>
              <a:off x="3492262" y="986384"/>
              <a:ext cx="283632" cy="482600"/>
            </a:xfrm>
            <a:custGeom>
              <a:avLst/>
              <a:gdLst>
                <a:gd name="connsiteX0" fmla="*/ 131233 w 283633"/>
                <a:gd name="connsiteY0" fmla="*/ 0 h 482600"/>
                <a:gd name="connsiteX1" fmla="*/ 93133 w 283633"/>
                <a:gd name="connsiteY1" fmla="*/ 63500 h 482600"/>
                <a:gd name="connsiteX2" fmla="*/ 93133 w 283633"/>
                <a:gd name="connsiteY2" fmla="*/ 165100 h 482600"/>
                <a:gd name="connsiteX3" fmla="*/ 139700 w 283633"/>
                <a:gd name="connsiteY3" fmla="*/ 254000 h 482600"/>
                <a:gd name="connsiteX4" fmla="*/ 165100 w 283633"/>
                <a:gd name="connsiteY4" fmla="*/ 287867 h 482600"/>
                <a:gd name="connsiteX5" fmla="*/ 131233 w 283633"/>
                <a:gd name="connsiteY5" fmla="*/ 338667 h 482600"/>
                <a:gd name="connsiteX6" fmla="*/ 0 w 283633"/>
                <a:gd name="connsiteY6" fmla="*/ 440267 h 482600"/>
                <a:gd name="connsiteX7" fmla="*/ 0 w 283633"/>
                <a:gd name="connsiteY7" fmla="*/ 440267 h 482600"/>
                <a:gd name="connsiteX8" fmla="*/ 0 w 283633"/>
                <a:gd name="connsiteY8" fmla="*/ 440267 h 482600"/>
                <a:gd name="connsiteX9" fmla="*/ 0 w 283633"/>
                <a:gd name="connsiteY9" fmla="*/ 440267 h 482600"/>
                <a:gd name="connsiteX10" fmla="*/ 12700 w 283633"/>
                <a:gd name="connsiteY10" fmla="*/ 482600 h 482600"/>
                <a:gd name="connsiteX11" fmla="*/ 203200 w 283633"/>
                <a:gd name="connsiteY11" fmla="*/ 325967 h 482600"/>
                <a:gd name="connsiteX12" fmla="*/ 275167 w 283633"/>
                <a:gd name="connsiteY12" fmla="*/ 186267 h 482600"/>
                <a:gd name="connsiteX13" fmla="*/ 283633 w 283633"/>
                <a:gd name="connsiteY13" fmla="*/ 71967 h 482600"/>
                <a:gd name="connsiteX14" fmla="*/ 262467 w 283633"/>
                <a:gd name="connsiteY14" fmla="*/ 16934 h 482600"/>
                <a:gd name="connsiteX15" fmla="*/ 203200 w 283633"/>
                <a:gd name="connsiteY15" fmla="*/ 0 h 482600"/>
                <a:gd name="connsiteX16" fmla="*/ 131233 w 283633"/>
                <a:gd name="connsiteY16" fmla="*/ 0 h 482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283633" h="482600">
                  <a:moveTo>
                    <a:pt x="131233" y="0"/>
                  </a:moveTo>
                  <a:lnTo>
                    <a:pt x="93133" y="63500"/>
                  </a:lnTo>
                  <a:lnTo>
                    <a:pt x="93133" y="165100"/>
                  </a:lnTo>
                  <a:lnTo>
                    <a:pt x="139700" y="254000"/>
                  </a:lnTo>
                  <a:lnTo>
                    <a:pt x="165100" y="287867"/>
                  </a:lnTo>
                  <a:lnTo>
                    <a:pt x="131233" y="3386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0" y="440267"/>
                  </a:lnTo>
                  <a:lnTo>
                    <a:pt x="12700" y="482600"/>
                  </a:lnTo>
                  <a:lnTo>
                    <a:pt x="203200" y="325967"/>
                  </a:lnTo>
                  <a:lnTo>
                    <a:pt x="275167" y="186267"/>
                  </a:lnTo>
                  <a:lnTo>
                    <a:pt x="283633" y="71967"/>
                  </a:lnTo>
                  <a:lnTo>
                    <a:pt x="262467" y="16934"/>
                  </a:lnTo>
                  <a:lnTo>
                    <a:pt x="203200" y="0"/>
                  </a:lnTo>
                  <a:lnTo>
                    <a:pt x="131233" y="0"/>
                  </a:lnTo>
                  <a:close/>
                </a:path>
              </a:pathLst>
            </a:custGeom>
            <a:solidFill>
              <a:schemeClr val="accent6">
                <a:lumMod val="60000"/>
                <a:lumOff val="40000"/>
                <a:alpha val="11000"/>
              </a:schemeClr>
            </a:solidFill>
            <a:ln w="12700" cmpd="sng"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  <p:sp>
          <p:nvSpPr>
            <p:cNvPr id="107" name="Freeform 106"/>
            <p:cNvSpPr/>
            <p:nvPr/>
          </p:nvSpPr>
          <p:spPr>
            <a:xfrm>
              <a:off x="3365481" y="859384"/>
              <a:ext cx="309033" cy="596900"/>
            </a:xfrm>
            <a:custGeom>
              <a:avLst/>
              <a:gdLst/>
              <a:ahLst/>
              <a:cxnLst/>
              <a:rect l="l" t="t" r="r" b="b"/>
              <a:pathLst>
                <a:path w="309033" h="596900">
                  <a:moveTo>
                    <a:pt x="118533" y="0"/>
                  </a:moveTo>
                  <a:lnTo>
                    <a:pt x="309033" y="63500"/>
                  </a:lnTo>
                  <a:lnTo>
                    <a:pt x="245533" y="194734"/>
                  </a:lnTo>
                  <a:lnTo>
                    <a:pt x="245533" y="300567"/>
                  </a:lnTo>
                  <a:lnTo>
                    <a:pt x="309033" y="414867"/>
                  </a:lnTo>
                  <a:lnTo>
                    <a:pt x="156633" y="596900"/>
                  </a:lnTo>
                  <a:lnTo>
                    <a:pt x="165100" y="508000"/>
                  </a:lnTo>
                  <a:lnTo>
                    <a:pt x="0" y="444500"/>
                  </a:lnTo>
                  <a:lnTo>
                    <a:pt x="357" y="421645"/>
                  </a:lnTo>
                  <a:lnTo>
                    <a:pt x="8450" y="423279"/>
                  </a:lnTo>
                  <a:cubicBezTo>
                    <a:pt x="73905" y="423279"/>
                    <a:pt x="126967" y="370217"/>
                    <a:pt x="126967" y="304762"/>
                  </a:cubicBezTo>
                  <a:cubicBezTo>
                    <a:pt x="126967" y="239307"/>
                    <a:pt x="73905" y="186245"/>
                    <a:pt x="8450" y="186245"/>
                  </a:cubicBezTo>
                  <a:lnTo>
                    <a:pt x="4021" y="187139"/>
                  </a:lnTo>
                  <a:lnTo>
                    <a:pt x="4233" y="173567"/>
                  </a:lnTo>
                  <a:close/>
                </a:path>
              </a:pathLst>
            </a:custGeom>
            <a:solidFill>
              <a:schemeClr val="tx2">
                <a:lumMod val="60000"/>
                <a:lumOff val="40000"/>
                <a:alpha val="16000"/>
              </a:schemeClr>
            </a:solidFill>
            <a:ln w="12700" cmpd="sng"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</p:grpSp>
      <p:cxnSp>
        <p:nvCxnSpPr>
          <p:cNvPr id="124" name="Straight Arrow Connector 123"/>
          <p:cNvCxnSpPr/>
          <p:nvPr/>
        </p:nvCxnSpPr>
        <p:spPr>
          <a:xfrm flipH="1">
            <a:off x="2030437" y="5076678"/>
            <a:ext cx="368580" cy="179716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Multiply 128"/>
          <p:cNvSpPr/>
          <p:nvPr/>
        </p:nvSpPr>
        <p:spPr>
          <a:xfrm rot="19278462">
            <a:off x="2153082" y="5055060"/>
            <a:ext cx="196336" cy="189892"/>
          </a:xfrm>
          <a:prstGeom prst="mathMultiply">
            <a:avLst>
              <a:gd name="adj1" fmla="val 5406"/>
            </a:avLst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/>
          </a:p>
        </p:txBody>
      </p:sp>
      <p:grpSp>
        <p:nvGrpSpPr>
          <p:cNvPr id="2" name="Group 1"/>
          <p:cNvGrpSpPr/>
          <p:nvPr/>
        </p:nvGrpSpPr>
        <p:grpSpPr>
          <a:xfrm>
            <a:off x="1685429" y="4623673"/>
            <a:ext cx="297183" cy="1189264"/>
            <a:chOff x="1183262" y="4438806"/>
            <a:chExt cx="237033" cy="1027603"/>
          </a:xfrm>
        </p:grpSpPr>
        <p:sp>
          <p:nvSpPr>
            <p:cNvPr id="123" name="Rectangle 122"/>
            <p:cNvSpPr/>
            <p:nvPr/>
          </p:nvSpPr>
          <p:spPr>
            <a:xfrm>
              <a:off x="1183262" y="4438806"/>
              <a:ext cx="237033" cy="1027603"/>
            </a:xfrm>
            <a:custGeom>
              <a:avLst/>
              <a:gdLst/>
              <a:ahLst/>
              <a:cxnLst/>
              <a:rect l="l" t="t" r="r" b="b"/>
              <a:pathLst>
                <a:path w="237033" h="1027603">
                  <a:moveTo>
                    <a:pt x="0" y="0"/>
                  </a:moveTo>
                  <a:lnTo>
                    <a:pt x="118532" y="0"/>
                  </a:lnTo>
                  <a:lnTo>
                    <a:pt x="118532" y="389958"/>
                  </a:lnTo>
                  <a:lnTo>
                    <a:pt x="237032" y="389958"/>
                  </a:lnTo>
                  <a:lnTo>
                    <a:pt x="237032" y="529139"/>
                  </a:lnTo>
                  <a:lnTo>
                    <a:pt x="237033" y="529144"/>
                  </a:lnTo>
                  <a:lnTo>
                    <a:pt x="237032" y="529149"/>
                  </a:lnTo>
                  <a:lnTo>
                    <a:pt x="237032" y="670826"/>
                  </a:lnTo>
                  <a:lnTo>
                    <a:pt x="118532" y="670826"/>
                  </a:lnTo>
                  <a:lnTo>
                    <a:pt x="118532" y="1027603"/>
                  </a:lnTo>
                  <a:lnTo>
                    <a:pt x="0" y="1027603"/>
                  </a:lnTo>
                  <a:close/>
                </a:path>
              </a:pathLst>
            </a:custGeom>
            <a:solidFill>
              <a:schemeClr val="accent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  <p:sp>
          <p:nvSpPr>
            <p:cNvPr id="132" name="Freeform 131"/>
            <p:cNvSpPr/>
            <p:nvPr/>
          </p:nvSpPr>
          <p:spPr>
            <a:xfrm>
              <a:off x="1295400" y="4830233"/>
              <a:ext cx="122767" cy="275167"/>
            </a:xfrm>
            <a:custGeom>
              <a:avLst/>
              <a:gdLst>
                <a:gd name="connsiteX0" fmla="*/ 8467 w 122767"/>
                <a:gd name="connsiteY0" fmla="*/ 0 h 275167"/>
                <a:gd name="connsiteX1" fmla="*/ 122767 w 122767"/>
                <a:gd name="connsiteY1" fmla="*/ 0 h 275167"/>
                <a:gd name="connsiteX2" fmla="*/ 122767 w 122767"/>
                <a:gd name="connsiteY2" fmla="*/ 275167 h 275167"/>
                <a:gd name="connsiteX3" fmla="*/ 0 w 122767"/>
                <a:gd name="connsiteY3" fmla="*/ 275167 h 275167"/>
                <a:gd name="connsiteX4" fmla="*/ 0 w 122767"/>
                <a:gd name="connsiteY4" fmla="*/ 275167 h 2751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22767" h="275167">
                  <a:moveTo>
                    <a:pt x="8467" y="0"/>
                  </a:moveTo>
                  <a:lnTo>
                    <a:pt x="122767" y="0"/>
                  </a:lnTo>
                  <a:lnTo>
                    <a:pt x="122767" y="275167"/>
                  </a:lnTo>
                  <a:lnTo>
                    <a:pt x="0" y="275167"/>
                  </a:lnTo>
                  <a:lnTo>
                    <a:pt x="0" y="275167"/>
                  </a:lnTo>
                </a:path>
              </a:pathLst>
            </a:custGeom>
            <a:ln w="19050" cmpd="sng">
              <a:solidFill>
                <a:srgbClr val="FFFF00"/>
              </a:solidFill>
              <a:prstDash val="sys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  <p:sp>
          <p:nvSpPr>
            <p:cNvPr id="133" name="Freeform 132"/>
            <p:cNvSpPr/>
            <p:nvPr/>
          </p:nvSpPr>
          <p:spPr>
            <a:xfrm>
              <a:off x="1295401" y="4830233"/>
              <a:ext cx="122767" cy="275167"/>
            </a:xfrm>
            <a:custGeom>
              <a:avLst/>
              <a:gdLst>
                <a:gd name="connsiteX0" fmla="*/ 8467 w 122767"/>
                <a:gd name="connsiteY0" fmla="*/ 0 h 275167"/>
                <a:gd name="connsiteX1" fmla="*/ 122767 w 122767"/>
                <a:gd name="connsiteY1" fmla="*/ 0 h 275167"/>
                <a:gd name="connsiteX2" fmla="*/ 122767 w 122767"/>
                <a:gd name="connsiteY2" fmla="*/ 275167 h 275167"/>
                <a:gd name="connsiteX3" fmla="*/ 0 w 122767"/>
                <a:gd name="connsiteY3" fmla="*/ 275167 h 275167"/>
                <a:gd name="connsiteX4" fmla="*/ 0 w 122767"/>
                <a:gd name="connsiteY4" fmla="*/ 275167 h 2751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22767" h="275167">
                  <a:moveTo>
                    <a:pt x="8467" y="0"/>
                  </a:moveTo>
                  <a:lnTo>
                    <a:pt x="122767" y="0"/>
                  </a:lnTo>
                  <a:lnTo>
                    <a:pt x="122767" y="275167"/>
                  </a:lnTo>
                  <a:lnTo>
                    <a:pt x="0" y="275167"/>
                  </a:lnTo>
                  <a:lnTo>
                    <a:pt x="0" y="275167"/>
                  </a:lnTo>
                </a:path>
              </a:pathLst>
            </a:custGeom>
            <a:ln w="9525" cmpd="sng">
              <a:solidFill>
                <a:schemeClr val="tx1"/>
              </a:solidFill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</p:grpSp>
      <p:grpSp>
        <p:nvGrpSpPr>
          <p:cNvPr id="87" name="Group 86"/>
          <p:cNvGrpSpPr/>
          <p:nvPr/>
        </p:nvGrpSpPr>
        <p:grpSpPr>
          <a:xfrm>
            <a:off x="3575100" y="5050485"/>
            <a:ext cx="297183" cy="1189264"/>
            <a:chOff x="1183262" y="4438806"/>
            <a:chExt cx="237033" cy="1027603"/>
          </a:xfrm>
        </p:grpSpPr>
        <p:sp>
          <p:nvSpPr>
            <p:cNvPr id="88" name="Rectangle 122"/>
            <p:cNvSpPr/>
            <p:nvPr/>
          </p:nvSpPr>
          <p:spPr>
            <a:xfrm>
              <a:off x="1183262" y="4438806"/>
              <a:ext cx="237033" cy="1027603"/>
            </a:xfrm>
            <a:custGeom>
              <a:avLst/>
              <a:gdLst/>
              <a:ahLst/>
              <a:cxnLst/>
              <a:rect l="l" t="t" r="r" b="b"/>
              <a:pathLst>
                <a:path w="237033" h="1027603">
                  <a:moveTo>
                    <a:pt x="0" y="0"/>
                  </a:moveTo>
                  <a:lnTo>
                    <a:pt x="118532" y="0"/>
                  </a:lnTo>
                  <a:lnTo>
                    <a:pt x="118532" y="389958"/>
                  </a:lnTo>
                  <a:lnTo>
                    <a:pt x="237032" y="389958"/>
                  </a:lnTo>
                  <a:lnTo>
                    <a:pt x="237032" y="529139"/>
                  </a:lnTo>
                  <a:lnTo>
                    <a:pt x="237033" y="529144"/>
                  </a:lnTo>
                  <a:lnTo>
                    <a:pt x="237032" y="529149"/>
                  </a:lnTo>
                  <a:lnTo>
                    <a:pt x="237032" y="670826"/>
                  </a:lnTo>
                  <a:lnTo>
                    <a:pt x="118532" y="670826"/>
                  </a:lnTo>
                  <a:lnTo>
                    <a:pt x="118532" y="1027603"/>
                  </a:lnTo>
                  <a:lnTo>
                    <a:pt x="0" y="1027603"/>
                  </a:lnTo>
                  <a:close/>
                </a:path>
              </a:pathLst>
            </a:custGeom>
            <a:solidFill>
              <a:schemeClr val="accent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  <p:sp>
          <p:nvSpPr>
            <p:cNvPr id="89" name="Freeform 88"/>
            <p:cNvSpPr/>
            <p:nvPr/>
          </p:nvSpPr>
          <p:spPr>
            <a:xfrm>
              <a:off x="1295400" y="4830233"/>
              <a:ext cx="122767" cy="275167"/>
            </a:xfrm>
            <a:custGeom>
              <a:avLst/>
              <a:gdLst>
                <a:gd name="connsiteX0" fmla="*/ 8467 w 122767"/>
                <a:gd name="connsiteY0" fmla="*/ 0 h 275167"/>
                <a:gd name="connsiteX1" fmla="*/ 122767 w 122767"/>
                <a:gd name="connsiteY1" fmla="*/ 0 h 275167"/>
                <a:gd name="connsiteX2" fmla="*/ 122767 w 122767"/>
                <a:gd name="connsiteY2" fmla="*/ 275167 h 275167"/>
                <a:gd name="connsiteX3" fmla="*/ 0 w 122767"/>
                <a:gd name="connsiteY3" fmla="*/ 275167 h 275167"/>
                <a:gd name="connsiteX4" fmla="*/ 0 w 122767"/>
                <a:gd name="connsiteY4" fmla="*/ 275167 h 2751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22767" h="275167">
                  <a:moveTo>
                    <a:pt x="8467" y="0"/>
                  </a:moveTo>
                  <a:lnTo>
                    <a:pt x="122767" y="0"/>
                  </a:lnTo>
                  <a:lnTo>
                    <a:pt x="122767" y="275167"/>
                  </a:lnTo>
                  <a:lnTo>
                    <a:pt x="0" y="275167"/>
                  </a:lnTo>
                  <a:lnTo>
                    <a:pt x="0" y="275167"/>
                  </a:lnTo>
                </a:path>
              </a:pathLst>
            </a:custGeom>
            <a:ln w="19050" cmpd="sng">
              <a:solidFill>
                <a:srgbClr val="FFFF00"/>
              </a:solidFill>
              <a:prstDash val="sys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  <p:sp>
          <p:nvSpPr>
            <p:cNvPr id="92" name="Freeform 91"/>
            <p:cNvSpPr/>
            <p:nvPr/>
          </p:nvSpPr>
          <p:spPr>
            <a:xfrm>
              <a:off x="1295401" y="4830233"/>
              <a:ext cx="122767" cy="275167"/>
            </a:xfrm>
            <a:custGeom>
              <a:avLst/>
              <a:gdLst>
                <a:gd name="connsiteX0" fmla="*/ 8467 w 122767"/>
                <a:gd name="connsiteY0" fmla="*/ 0 h 275167"/>
                <a:gd name="connsiteX1" fmla="*/ 122767 w 122767"/>
                <a:gd name="connsiteY1" fmla="*/ 0 h 275167"/>
                <a:gd name="connsiteX2" fmla="*/ 122767 w 122767"/>
                <a:gd name="connsiteY2" fmla="*/ 275167 h 275167"/>
                <a:gd name="connsiteX3" fmla="*/ 0 w 122767"/>
                <a:gd name="connsiteY3" fmla="*/ 275167 h 275167"/>
                <a:gd name="connsiteX4" fmla="*/ 0 w 122767"/>
                <a:gd name="connsiteY4" fmla="*/ 275167 h 2751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22767" h="275167">
                  <a:moveTo>
                    <a:pt x="8467" y="0"/>
                  </a:moveTo>
                  <a:lnTo>
                    <a:pt x="122767" y="0"/>
                  </a:lnTo>
                  <a:lnTo>
                    <a:pt x="122767" y="275167"/>
                  </a:lnTo>
                  <a:lnTo>
                    <a:pt x="0" y="275167"/>
                  </a:lnTo>
                  <a:lnTo>
                    <a:pt x="0" y="275167"/>
                  </a:lnTo>
                </a:path>
              </a:pathLst>
            </a:custGeom>
            <a:ln w="9525" cmpd="sng">
              <a:solidFill>
                <a:schemeClr val="tx1"/>
              </a:solidFill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</p:grpSp>
      <p:sp>
        <p:nvSpPr>
          <p:cNvPr id="93" name="TextBox 92"/>
          <p:cNvSpPr txBox="1"/>
          <p:nvPr/>
        </p:nvSpPr>
        <p:spPr>
          <a:xfrm>
            <a:off x="1637387" y="5142747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Mut</a:t>
            </a:r>
            <a:endParaRPr lang="en-US" sz="8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3531676" y="5564234"/>
            <a:ext cx="482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Mut</a:t>
            </a:r>
            <a:endParaRPr lang="en-US" sz="800" b="1" dirty="0"/>
          </a:p>
        </p:txBody>
      </p:sp>
      <p:sp>
        <p:nvSpPr>
          <p:cNvPr id="111" name="110 CuadroTexto"/>
          <p:cNvSpPr txBox="1"/>
          <p:nvPr/>
        </p:nvSpPr>
        <p:spPr>
          <a:xfrm>
            <a:off x="4925683" y="527858"/>
            <a:ext cx="509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A</a:t>
            </a:r>
          </a:p>
        </p:txBody>
      </p:sp>
      <p:sp>
        <p:nvSpPr>
          <p:cNvPr id="112" name="111 CuadroTexto"/>
          <p:cNvSpPr txBox="1"/>
          <p:nvPr/>
        </p:nvSpPr>
        <p:spPr>
          <a:xfrm>
            <a:off x="4425811" y="2707719"/>
            <a:ext cx="509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B</a:t>
            </a:r>
          </a:p>
        </p:txBody>
      </p:sp>
      <p:sp>
        <p:nvSpPr>
          <p:cNvPr id="113" name="112 CuadroTexto"/>
          <p:cNvSpPr txBox="1"/>
          <p:nvPr/>
        </p:nvSpPr>
        <p:spPr>
          <a:xfrm>
            <a:off x="3394833" y="4753341"/>
            <a:ext cx="509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D</a:t>
            </a:r>
          </a:p>
        </p:txBody>
      </p:sp>
      <p:sp>
        <p:nvSpPr>
          <p:cNvPr id="114" name="TextBox 15"/>
          <p:cNvSpPr txBox="1"/>
          <p:nvPr/>
        </p:nvSpPr>
        <p:spPr>
          <a:xfrm>
            <a:off x="2803235" y="1296036"/>
            <a:ext cx="577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Normal</a:t>
            </a:r>
            <a:endParaRPr lang="en-US" sz="800" b="1" dirty="0"/>
          </a:p>
        </p:txBody>
      </p:sp>
      <p:sp>
        <p:nvSpPr>
          <p:cNvPr id="116" name="TextBox 15"/>
          <p:cNvSpPr txBox="1"/>
          <p:nvPr/>
        </p:nvSpPr>
        <p:spPr>
          <a:xfrm>
            <a:off x="2190840" y="2283313"/>
            <a:ext cx="577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Lys1 mutation</a:t>
            </a:r>
            <a:endParaRPr lang="en-US" sz="800" b="1" dirty="0"/>
          </a:p>
        </p:txBody>
      </p:sp>
      <p:sp>
        <p:nvSpPr>
          <p:cNvPr id="117" name="TextBox 15"/>
          <p:cNvSpPr txBox="1"/>
          <p:nvPr/>
        </p:nvSpPr>
        <p:spPr>
          <a:xfrm>
            <a:off x="1638997" y="3150605"/>
            <a:ext cx="5773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Binding site</a:t>
            </a:r>
            <a:r>
              <a:rPr lang="en-US" sz="800" b="1" dirty="0"/>
              <a:t> </a:t>
            </a:r>
            <a:r>
              <a:rPr lang="en-US" sz="800" b="1" dirty="0" smtClean="0"/>
              <a:t>mutation</a:t>
            </a:r>
          </a:p>
        </p:txBody>
      </p:sp>
      <p:grpSp>
        <p:nvGrpSpPr>
          <p:cNvPr id="122" name="121 Grupo"/>
          <p:cNvGrpSpPr/>
          <p:nvPr/>
        </p:nvGrpSpPr>
        <p:grpSpPr>
          <a:xfrm>
            <a:off x="3404675" y="3134663"/>
            <a:ext cx="298794" cy="326438"/>
            <a:chOff x="3233730" y="2938826"/>
            <a:chExt cx="139398" cy="184885"/>
          </a:xfrm>
        </p:grpSpPr>
        <p:sp>
          <p:nvSpPr>
            <p:cNvPr id="121" name="Freeform 120"/>
            <p:cNvSpPr/>
            <p:nvPr/>
          </p:nvSpPr>
          <p:spPr>
            <a:xfrm>
              <a:off x="3242316" y="2968058"/>
              <a:ext cx="109993" cy="77921"/>
            </a:xfrm>
            <a:custGeom>
              <a:avLst/>
              <a:gdLst>
                <a:gd name="connsiteX0" fmla="*/ 0 w 385233"/>
                <a:gd name="connsiteY0" fmla="*/ 0 h 258233"/>
                <a:gd name="connsiteX1" fmla="*/ 220133 w 385233"/>
                <a:gd name="connsiteY1" fmla="*/ 12700 h 258233"/>
                <a:gd name="connsiteX2" fmla="*/ 325966 w 385233"/>
                <a:gd name="connsiteY2" fmla="*/ 76200 h 258233"/>
                <a:gd name="connsiteX3" fmla="*/ 385233 w 385233"/>
                <a:gd name="connsiteY3" fmla="*/ 258233 h 258233"/>
                <a:gd name="connsiteX4" fmla="*/ 385233 w 385233"/>
                <a:gd name="connsiteY4" fmla="*/ 258233 h 2582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85233" h="258233">
                  <a:moveTo>
                    <a:pt x="0" y="0"/>
                  </a:moveTo>
                  <a:cubicBezTo>
                    <a:pt x="82902" y="0"/>
                    <a:pt x="165805" y="0"/>
                    <a:pt x="220133" y="12700"/>
                  </a:cubicBezTo>
                  <a:cubicBezTo>
                    <a:pt x="274461" y="25400"/>
                    <a:pt x="298449" y="35278"/>
                    <a:pt x="325966" y="76200"/>
                  </a:cubicBezTo>
                  <a:cubicBezTo>
                    <a:pt x="353483" y="117122"/>
                    <a:pt x="385233" y="258233"/>
                    <a:pt x="385233" y="258233"/>
                  </a:cubicBezTo>
                  <a:lnTo>
                    <a:pt x="385233" y="258233"/>
                  </a:lnTo>
                </a:path>
              </a:pathLst>
            </a:custGeom>
            <a:ln w="6350" cmpd="sng">
              <a:solidFill>
                <a:srgbClr val="000000"/>
              </a:solidFill>
              <a:prstDash val="sysDash"/>
              <a:headEnd type="triangle" w="sm" len="sm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400" b="1"/>
            </a:p>
          </p:txBody>
        </p:sp>
        <p:sp>
          <p:nvSpPr>
            <p:cNvPr id="118" name="117 Forma libre"/>
            <p:cNvSpPr/>
            <p:nvPr/>
          </p:nvSpPr>
          <p:spPr>
            <a:xfrm rot="21314496">
              <a:off x="3233730" y="2938826"/>
              <a:ext cx="139398" cy="184885"/>
            </a:xfrm>
            <a:custGeom>
              <a:avLst/>
              <a:gdLst>
                <a:gd name="connsiteX0" fmla="*/ 100012 w 226218"/>
                <a:gd name="connsiteY0" fmla="*/ 0 h 273844"/>
                <a:gd name="connsiteX1" fmla="*/ 0 w 226218"/>
                <a:gd name="connsiteY1" fmla="*/ 273844 h 273844"/>
                <a:gd name="connsiteX2" fmla="*/ 226218 w 226218"/>
                <a:gd name="connsiteY2" fmla="*/ 92869 h 2738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26218" h="273844">
                  <a:moveTo>
                    <a:pt x="100012" y="0"/>
                  </a:moveTo>
                  <a:lnTo>
                    <a:pt x="0" y="273844"/>
                  </a:lnTo>
                  <a:lnTo>
                    <a:pt x="226218" y="92869"/>
                  </a:lnTo>
                </a:path>
              </a:pathLst>
            </a:custGeom>
            <a:ln w="63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0" name="TextBox 54"/>
            <p:cNvSpPr txBox="1"/>
            <p:nvPr/>
          </p:nvSpPr>
          <p:spPr>
            <a:xfrm>
              <a:off x="3255402" y="2980730"/>
              <a:ext cx="75702" cy="1045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00" b="1" dirty="0" smtClean="0">
                  <a:latin typeface="Symbol" pitchFamily="18" charset="2"/>
                </a:rPr>
                <a:t>q</a:t>
              </a:r>
              <a:endParaRPr lang="en-US" sz="500" b="1" dirty="0">
                <a:latin typeface="Symbol" pitchFamily="18" charset="2"/>
              </a:endParaRPr>
            </a:p>
          </p:txBody>
        </p:sp>
      </p:grpSp>
      <p:sp>
        <p:nvSpPr>
          <p:cNvPr id="127" name="TextBox 15"/>
          <p:cNvSpPr txBox="1"/>
          <p:nvPr/>
        </p:nvSpPr>
        <p:spPr>
          <a:xfrm>
            <a:off x="5382986" y="2680101"/>
            <a:ext cx="1002574" cy="4924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SUMOylation</a:t>
            </a:r>
          </a:p>
          <a:p>
            <a:pPr algn="ctr"/>
            <a:r>
              <a:rPr lang="en-US" sz="800" dirty="0" smtClean="0"/>
              <a:t>Similar functional outcome</a:t>
            </a:r>
            <a:endParaRPr lang="en-US" sz="800" dirty="0"/>
          </a:p>
        </p:txBody>
      </p:sp>
      <p:cxnSp>
        <p:nvCxnSpPr>
          <p:cNvPr id="128" name="Straight Arrow Connector 14"/>
          <p:cNvCxnSpPr/>
          <p:nvPr/>
        </p:nvCxnSpPr>
        <p:spPr>
          <a:xfrm flipV="1">
            <a:off x="5429118" y="3242622"/>
            <a:ext cx="232133" cy="165198"/>
          </a:xfrm>
          <a:prstGeom prst="straightConnector1">
            <a:avLst/>
          </a:prstGeom>
          <a:ln>
            <a:prstDash val="sysDash"/>
            <a:headEnd type="none"/>
            <a:tailEnd type="stealth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Straight Arrow Connector 14"/>
          <p:cNvCxnSpPr/>
          <p:nvPr/>
        </p:nvCxnSpPr>
        <p:spPr>
          <a:xfrm>
            <a:off x="5666804" y="2291315"/>
            <a:ext cx="85113" cy="304511"/>
          </a:xfrm>
          <a:prstGeom prst="straightConnector1">
            <a:avLst/>
          </a:prstGeom>
          <a:ln>
            <a:prstDash val="sysDash"/>
            <a:headEnd type="none"/>
            <a:tailEnd type="stealth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1" name="TextBox 15"/>
          <p:cNvSpPr txBox="1"/>
          <p:nvPr/>
        </p:nvSpPr>
        <p:spPr>
          <a:xfrm>
            <a:off x="4925683" y="5449409"/>
            <a:ext cx="1164785" cy="4924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No Modification</a:t>
            </a:r>
          </a:p>
          <a:p>
            <a:pPr algn="ctr"/>
            <a:r>
              <a:rPr lang="en-US" sz="800" dirty="0" smtClean="0"/>
              <a:t>Different  functional outcome</a:t>
            </a:r>
            <a:endParaRPr lang="en-US" sz="800" dirty="0"/>
          </a:p>
        </p:txBody>
      </p:sp>
      <p:cxnSp>
        <p:nvCxnSpPr>
          <p:cNvPr id="142" name="Straight Arrow Connector 14"/>
          <p:cNvCxnSpPr/>
          <p:nvPr/>
        </p:nvCxnSpPr>
        <p:spPr>
          <a:xfrm flipV="1">
            <a:off x="4525294" y="5692241"/>
            <a:ext cx="296488" cy="120696"/>
          </a:xfrm>
          <a:prstGeom prst="straightConnector1">
            <a:avLst/>
          </a:prstGeom>
          <a:ln>
            <a:prstDash val="sysDash"/>
            <a:headEnd type="none"/>
            <a:tailEnd type="stealth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4687862" y="152400"/>
            <a:ext cx="1992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_tradnl" dirty="0" err="1" smtClean="0"/>
              <a:t>Supp</a:t>
            </a:r>
            <a:r>
              <a:rPr lang="es-ES_tradnl" dirty="0" smtClean="0"/>
              <a:t>. </a:t>
            </a:r>
            <a:r>
              <a:rPr lang="es-ES_tradnl" dirty="0"/>
              <a:t>Figure </a:t>
            </a:r>
            <a:r>
              <a:rPr lang="es-ES_tradnl" dirty="0" smtClean="0"/>
              <a:t>2</a:t>
            </a:r>
            <a:endParaRPr lang="es-ES_tradnl" dirty="0"/>
          </a:p>
        </p:txBody>
      </p:sp>
    </p:spTree>
    <p:extLst>
      <p:ext uri="{BB962C8B-B14F-4D97-AF65-F5344CB8AC3E}">
        <p14:creationId xmlns:p14="http://schemas.microsoft.com/office/powerpoint/2010/main" val="37298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8</Words>
  <Application>Microsoft Macintosh PowerPoint</Application>
  <PresentationFormat>On-screen Show (4:3)</PresentationFormat>
  <Paragraphs>51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Wilkinson</dc:creator>
  <cp:lastModifiedBy>Kevin Wilkinson</cp:lastModifiedBy>
  <cp:revision>1</cp:revision>
  <dcterms:created xsi:type="dcterms:W3CDTF">2015-06-30T03:31:36Z</dcterms:created>
  <dcterms:modified xsi:type="dcterms:W3CDTF">2015-06-30T03:34:45Z</dcterms:modified>
</cp:coreProperties>
</file>